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notesSlides/notesSlide7.xml" ContentType="application/vnd.openxmlformats-officedocument.presentationml.notesSlide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notesSlides/notesSlide8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17"/>
  </p:notesMasterIdLst>
  <p:handoutMasterIdLst>
    <p:handoutMasterId r:id="rId18"/>
  </p:handoutMasterIdLst>
  <p:sldIdLst>
    <p:sldId id="747" r:id="rId2"/>
    <p:sldId id="748" r:id="rId3"/>
    <p:sldId id="738" r:id="rId4"/>
    <p:sldId id="739" r:id="rId5"/>
    <p:sldId id="744" r:id="rId6"/>
    <p:sldId id="742" r:id="rId7"/>
    <p:sldId id="757" r:id="rId8"/>
    <p:sldId id="758" r:id="rId9"/>
    <p:sldId id="773" r:id="rId10"/>
    <p:sldId id="774" r:id="rId11"/>
    <p:sldId id="745" r:id="rId12"/>
    <p:sldId id="734" r:id="rId13"/>
    <p:sldId id="749" r:id="rId14"/>
    <p:sldId id="732" r:id="rId15"/>
    <p:sldId id="778" r:id="rId16"/>
  </p:sldIdLst>
  <p:sldSz cx="10287000" cy="6858000" type="35mm"/>
  <p:notesSz cx="6807200" cy="9939338"/>
  <p:custDataLst>
    <p:tags r:id="rId19"/>
  </p:custDataLst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ヒラギノ角ゴ Pro W3" charset="0"/>
        <a:ea typeface="ヒラギノ角ゴ Pro W3" charset="0"/>
        <a:cs typeface="ヒラギノ角ゴ Pro W3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2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>
          <p15:clr>
            <a:srgbClr val="A4A3A4"/>
          </p15:clr>
        </p15:guide>
        <p15:guide id="2" pos="2144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dekatsu Iha" initials="HI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scaleToFitPaper="1" frameSlides="1"/>
  <p:clrMru>
    <a:srgbClr val="008F00"/>
    <a:srgbClr val="FC6708"/>
    <a:srgbClr val="0432FF"/>
    <a:srgbClr val="76D6FF"/>
    <a:srgbClr val="FFFFFF"/>
    <a:srgbClr val="456321"/>
    <a:srgbClr val="FFE194"/>
    <a:srgbClr val="00FF00"/>
    <a:srgbClr val="FF9230"/>
    <a:srgbClr val="FF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004" autoAdjust="0"/>
    <p:restoredTop sz="97867" autoAdjust="0"/>
  </p:normalViewPr>
  <p:slideViewPr>
    <p:cSldViewPr showGuides="1">
      <p:cViewPr varScale="1">
        <p:scale>
          <a:sx n="124" d="100"/>
          <a:sy n="124" d="100"/>
        </p:scale>
        <p:origin x="1256" y="168"/>
      </p:cViewPr>
      <p:guideLst>
        <p:guide orient="horz" pos="2160"/>
        <p:guide pos="32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398" y="-84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ihahidekatsu\Desktop\%20%20ResBiz\%201.&#35542;&#25991;(&#25237;&#31295;&amp;&#23529;&#26619;)&#12539;&#29305;&#35377;\%20%20%20&#35542;&#25991;\%20%20%20%201.ATL%20vs%20Len%202020\%20%20%20%20ATL%20vs%20LEN%20Oncoimmunology\%20%20Fig%20Tab%20Supples\%20%20Supple2-8\%20Suppl9%20SCID-HuT102%20LEN%20BW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hiha\Desktop\%20%20ResBiz\%201.&#35542;&#25991;(&#25237;&#31295;&amp;&#23529;&#26619;)&#12539;&#29305;&#35377;\%20%20%20&#35542;&#25991;\%20%20%20%201.ATL%20vs%20Len%202020\%20%20%20%20210317%20ATL%20vs%20Len%20manuscript\%20%20%20%20ATL%20vs%20Len%20Manu%20Fig%20Tab%20Data\%20%20%20%20ATLvsLen2019&amp;2020%20Update\%20%20%20%20210325%20HBZ%20RT-PCR\%20%20%20%20Supple%204%20210325_TL-Om1_IMiDs_12hours_HBZ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271981627296599E-2"/>
          <c:y val="3.05555555555556E-2"/>
          <c:w val="0.91645024059492597"/>
          <c:h val="0.83579155730533705"/>
        </c:manualLayout>
      </c:layout>
      <c:lineChart>
        <c:grouping val="standard"/>
        <c:varyColors val="0"/>
        <c:ser>
          <c:idx val="0"/>
          <c:order val="0"/>
          <c:tx>
            <c:strRef>
              <c:f>Sheet1!$M$30</c:f>
              <c:strCache>
                <c:ptCount val="1"/>
                <c:pt idx="0">
                  <c:v>0mg/kg BW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35:$V$35</c:f>
                <c:numCache>
                  <c:formatCode>General</c:formatCode>
                  <c:ptCount val="9"/>
                  <c:pt idx="0">
                    <c:v>1.2638670816189499</c:v>
                  </c:pt>
                  <c:pt idx="1">
                    <c:v>0.987493797448876</c:v>
                  </c:pt>
                  <c:pt idx="2">
                    <c:v>1.05619316415133</c:v>
                  </c:pt>
                  <c:pt idx="3">
                    <c:v>1.07639026379841</c:v>
                  </c:pt>
                  <c:pt idx="4">
                    <c:v>1.1069706409837601</c:v>
                  </c:pt>
                  <c:pt idx="5">
                    <c:v>1.16658475902954</c:v>
                  </c:pt>
                  <c:pt idx="6">
                    <c:v>1.3875590077542601</c:v>
                  </c:pt>
                  <c:pt idx="7">
                    <c:v>1.3018694250960801</c:v>
                  </c:pt>
                  <c:pt idx="8">
                    <c:v>1.1260195380187701</c:v>
                  </c:pt>
                </c:numCache>
              </c:numRef>
            </c:plus>
            <c:minus>
              <c:numRef>
                <c:f>Sheet1!$N$35:$V$35</c:f>
                <c:numCache>
                  <c:formatCode>General</c:formatCode>
                  <c:ptCount val="9"/>
                  <c:pt idx="0">
                    <c:v>1.2638670816189499</c:v>
                  </c:pt>
                  <c:pt idx="1">
                    <c:v>0.987493797448876</c:v>
                  </c:pt>
                  <c:pt idx="2">
                    <c:v>1.05619316415133</c:v>
                  </c:pt>
                  <c:pt idx="3">
                    <c:v>1.07639026379841</c:v>
                  </c:pt>
                  <c:pt idx="4">
                    <c:v>1.1069706409837601</c:v>
                  </c:pt>
                  <c:pt idx="5">
                    <c:v>1.16658475902954</c:v>
                  </c:pt>
                  <c:pt idx="6">
                    <c:v>1.3875590077542601</c:v>
                  </c:pt>
                  <c:pt idx="7">
                    <c:v>1.3018694250960801</c:v>
                  </c:pt>
                  <c:pt idx="8">
                    <c:v>1.12601953801877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28:$V$28</c:f>
              <c:strCache>
                <c:ptCount val="9"/>
                <c:pt idx="0">
                  <c:v>Day 10</c:v>
                </c:pt>
                <c:pt idx="1">
                  <c:v>Day 14</c:v>
                </c:pt>
                <c:pt idx="2">
                  <c:v>Day 17</c:v>
                </c:pt>
                <c:pt idx="3">
                  <c:v>Day 21</c:v>
                </c:pt>
                <c:pt idx="4">
                  <c:v>Day 24</c:v>
                </c:pt>
                <c:pt idx="5">
                  <c:v>Day 28</c:v>
                </c:pt>
                <c:pt idx="6">
                  <c:v>Day 31</c:v>
                </c:pt>
                <c:pt idx="7">
                  <c:v>Day 34</c:v>
                </c:pt>
                <c:pt idx="8">
                  <c:v>Day 38</c:v>
                </c:pt>
              </c:strCache>
            </c:strRef>
          </c:cat>
          <c:val>
            <c:numRef>
              <c:f>Sheet1!$N$30:$V$30</c:f>
              <c:numCache>
                <c:formatCode>General</c:formatCode>
                <c:ptCount val="9"/>
                <c:pt idx="0">
                  <c:v>17.96</c:v>
                </c:pt>
                <c:pt idx="1">
                  <c:v>18.446000000000002</c:v>
                </c:pt>
                <c:pt idx="2">
                  <c:v>18.384</c:v>
                </c:pt>
                <c:pt idx="3">
                  <c:v>18.937999999999999</c:v>
                </c:pt>
                <c:pt idx="4">
                  <c:v>19.056000000000001</c:v>
                </c:pt>
                <c:pt idx="5">
                  <c:v>19.21</c:v>
                </c:pt>
                <c:pt idx="6">
                  <c:v>19.96</c:v>
                </c:pt>
                <c:pt idx="7">
                  <c:v>19.576000000000001</c:v>
                </c:pt>
                <c:pt idx="8">
                  <c:v>19.8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5D2-0D41-A71A-D88D049E0EBB}"/>
            </c:ext>
          </c:extLst>
        </c:ser>
        <c:ser>
          <c:idx val="1"/>
          <c:order val="1"/>
          <c:tx>
            <c:strRef>
              <c:f>Sheet1!$M$31</c:f>
              <c:strCache>
                <c:ptCount val="1"/>
                <c:pt idx="0">
                  <c:v>10mg/kg BW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tar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37:$V$37</c:f>
                <c:numCache>
                  <c:formatCode>General</c:formatCode>
                  <c:ptCount val="9"/>
                  <c:pt idx="0">
                    <c:v>0.737888880523349</c:v>
                  </c:pt>
                  <c:pt idx="1">
                    <c:v>0.79738071208175099</c:v>
                  </c:pt>
                  <c:pt idx="2">
                    <c:v>0.88492711564286497</c:v>
                  </c:pt>
                  <c:pt idx="3">
                    <c:v>0.808084154033477</c:v>
                  </c:pt>
                  <c:pt idx="4">
                    <c:v>0.68180935751865301</c:v>
                  </c:pt>
                  <c:pt idx="5">
                    <c:v>0.93066857688438198</c:v>
                  </c:pt>
                  <c:pt idx="6">
                    <c:v>0.94296129294897302</c:v>
                  </c:pt>
                  <c:pt idx="7">
                    <c:v>1.00465715545155</c:v>
                  </c:pt>
                  <c:pt idx="8">
                    <c:v>1.1059584078978699</c:v>
                  </c:pt>
                </c:numCache>
              </c:numRef>
            </c:plus>
            <c:minus>
              <c:numRef>
                <c:f>Sheet1!$N$37:$V$37</c:f>
                <c:numCache>
                  <c:formatCode>General</c:formatCode>
                  <c:ptCount val="9"/>
                  <c:pt idx="0">
                    <c:v>0.737888880523349</c:v>
                  </c:pt>
                  <c:pt idx="1">
                    <c:v>0.79738071208175099</c:v>
                  </c:pt>
                  <c:pt idx="2">
                    <c:v>0.88492711564286497</c:v>
                  </c:pt>
                  <c:pt idx="3">
                    <c:v>0.808084154033477</c:v>
                  </c:pt>
                  <c:pt idx="4">
                    <c:v>0.68180935751865301</c:v>
                  </c:pt>
                  <c:pt idx="5">
                    <c:v>0.93066857688438198</c:v>
                  </c:pt>
                  <c:pt idx="6">
                    <c:v>0.94296129294897302</c:v>
                  </c:pt>
                  <c:pt idx="7">
                    <c:v>1.00465715545155</c:v>
                  </c:pt>
                  <c:pt idx="8">
                    <c:v>1.10595840789786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28:$V$28</c:f>
              <c:strCache>
                <c:ptCount val="9"/>
                <c:pt idx="0">
                  <c:v>Day 10</c:v>
                </c:pt>
                <c:pt idx="1">
                  <c:v>Day 14</c:v>
                </c:pt>
                <c:pt idx="2">
                  <c:v>Day 17</c:v>
                </c:pt>
                <c:pt idx="3">
                  <c:v>Day 21</c:v>
                </c:pt>
                <c:pt idx="4">
                  <c:v>Day 24</c:v>
                </c:pt>
                <c:pt idx="5">
                  <c:v>Day 28</c:v>
                </c:pt>
                <c:pt idx="6">
                  <c:v>Day 31</c:v>
                </c:pt>
                <c:pt idx="7">
                  <c:v>Day 34</c:v>
                </c:pt>
                <c:pt idx="8">
                  <c:v>Day 38</c:v>
                </c:pt>
              </c:strCache>
            </c:strRef>
          </c:cat>
          <c:val>
            <c:numRef>
              <c:f>Sheet1!$N$31:$V$31</c:f>
              <c:numCache>
                <c:formatCode>General</c:formatCode>
                <c:ptCount val="9"/>
                <c:pt idx="0">
                  <c:v>17.84</c:v>
                </c:pt>
                <c:pt idx="1">
                  <c:v>18.158000000000001</c:v>
                </c:pt>
                <c:pt idx="2">
                  <c:v>17.722000000000001</c:v>
                </c:pt>
                <c:pt idx="3">
                  <c:v>18.626000000000001</c:v>
                </c:pt>
                <c:pt idx="4">
                  <c:v>18.184000000000001</c:v>
                </c:pt>
                <c:pt idx="5">
                  <c:v>18.082000000000001</c:v>
                </c:pt>
                <c:pt idx="6">
                  <c:v>18.866</c:v>
                </c:pt>
                <c:pt idx="7">
                  <c:v>18.64</c:v>
                </c:pt>
                <c:pt idx="8">
                  <c:v>18.9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5D2-0D41-A71A-D88D049E0EBB}"/>
            </c:ext>
          </c:extLst>
        </c:ser>
        <c:ser>
          <c:idx val="2"/>
          <c:order val="2"/>
          <c:tx>
            <c:strRef>
              <c:f>Sheet1!$M$32</c:f>
              <c:strCache>
                <c:ptCount val="1"/>
                <c:pt idx="0">
                  <c:v>50mg/kg BW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diamond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38:$V$38</c:f>
                <c:numCache>
                  <c:formatCode>General</c:formatCode>
                  <c:ptCount val="9"/>
                  <c:pt idx="0">
                    <c:v>0.67282687223385995</c:v>
                  </c:pt>
                  <c:pt idx="1">
                    <c:v>0.765960834507875</c:v>
                  </c:pt>
                  <c:pt idx="2">
                    <c:v>0.872774885064872</c:v>
                  </c:pt>
                  <c:pt idx="3">
                    <c:v>0.91272339731158403</c:v>
                  </c:pt>
                  <c:pt idx="4">
                    <c:v>0.98805667853620605</c:v>
                  </c:pt>
                  <c:pt idx="5">
                    <c:v>0.870599793246013</c:v>
                  </c:pt>
                  <c:pt idx="6">
                    <c:v>1.0431299056205801</c:v>
                  </c:pt>
                  <c:pt idx="7">
                    <c:v>1.0112487330029201</c:v>
                  </c:pt>
                  <c:pt idx="8">
                    <c:v>1.00375295765442</c:v>
                  </c:pt>
                </c:numCache>
              </c:numRef>
            </c:plus>
            <c:minus>
              <c:numRef>
                <c:f>Sheet1!$N$38:$V$38</c:f>
                <c:numCache>
                  <c:formatCode>General</c:formatCode>
                  <c:ptCount val="9"/>
                  <c:pt idx="0">
                    <c:v>0.67282687223385995</c:v>
                  </c:pt>
                  <c:pt idx="1">
                    <c:v>0.765960834507875</c:v>
                  </c:pt>
                  <c:pt idx="2">
                    <c:v>0.872774885064872</c:v>
                  </c:pt>
                  <c:pt idx="3">
                    <c:v>0.91272339731158403</c:v>
                  </c:pt>
                  <c:pt idx="4">
                    <c:v>0.98805667853620605</c:v>
                  </c:pt>
                  <c:pt idx="5">
                    <c:v>0.870599793246013</c:v>
                  </c:pt>
                  <c:pt idx="6">
                    <c:v>1.0431299056205801</c:v>
                  </c:pt>
                  <c:pt idx="7">
                    <c:v>1.0112487330029201</c:v>
                  </c:pt>
                  <c:pt idx="8">
                    <c:v>1.003752957654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28:$V$28</c:f>
              <c:strCache>
                <c:ptCount val="9"/>
                <c:pt idx="0">
                  <c:v>Day 10</c:v>
                </c:pt>
                <c:pt idx="1">
                  <c:v>Day 14</c:v>
                </c:pt>
                <c:pt idx="2">
                  <c:v>Day 17</c:v>
                </c:pt>
                <c:pt idx="3">
                  <c:v>Day 21</c:v>
                </c:pt>
                <c:pt idx="4">
                  <c:v>Day 24</c:v>
                </c:pt>
                <c:pt idx="5">
                  <c:v>Day 28</c:v>
                </c:pt>
                <c:pt idx="6">
                  <c:v>Day 31</c:v>
                </c:pt>
                <c:pt idx="7">
                  <c:v>Day 34</c:v>
                </c:pt>
                <c:pt idx="8">
                  <c:v>Day 38</c:v>
                </c:pt>
              </c:strCache>
            </c:strRef>
          </c:cat>
          <c:val>
            <c:numRef>
              <c:f>Sheet1!$N$32:$V$32</c:f>
              <c:numCache>
                <c:formatCode>General</c:formatCode>
                <c:ptCount val="9"/>
                <c:pt idx="0">
                  <c:v>17.72</c:v>
                </c:pt>
                <c:pt idx="1">
                  <c:v>17.808</c:v>
                </c:pt>
                <c:pt idx="2">
                  <c:v>17.731999999999999</c:v>
                </c:pt>
                <c:pt idx="3">
                  <c:v>17.98</c:v>
                </c:pt>
                <c:pt idx="4">
                  <c:v>18.004000000000001</c:v>
                </c:pt>
                <c:pt idx="5">
                  <c:v>18.344000000000001</c:v>
                </c:pt>
                <c:pt idx="6">
                  <c:v>18.788</c:v>
                </c:pt>
                <c:pt idx="7">
                  <c:v>18.992000000000001</c:v>
                </c:pt>
                <c:pt idx="8">
                  <c:v>19.335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5D2-0D41-A71A-D88D049E0EBB}"/>
            </c:ext>
          </c:extLst>
        </c:ser>
        <c:ser>
          <c:idx val="3"/>
          <c:order val="3"/>
          <c:tx>
            <c:strRef>
              <c:f>Sheet1!$M$33</c:f>
              <c:strCache>
                <c:ptCount val="1"/>
                <c:pt idx="0">
                  <c:v>100mg/kg BW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38:$V$38</c:f>
                <c:numCache>
                  <c:formatCode>General</c:formatCode>
                  <c:ptCount val="9"/>
                  <c:pt idx="0">
                    <c:v>0.67282687223385995</c:v>
                  </c:pt>
                  <c:pt idx="1">
                    <c:v>0.765960834507875</c:v>
                  </c:pt>
                  <c:pt idx="2">
                    <c:v>0.872774885064872</c:v>
                  </c:pt>
                  <c:pt idx="3">
                    <c:v>0.91272339731158403</c:v>
                  </c:pt>
                  <c:pt idx="4">
                    <c:v>0.98805667853620605</c:v>
                  </c:pt>
                  <c:pt idx="5">
                    <c:v>0.870599793246013</c:v>
                  </c:pt>
                  <c:pt idx="6">
                    <c:v>1.0431299056205801</c:v>
                  </c:pt>
                  <c:pt idx="7">
                    <c:v>1.0112487330029201</c:v>
                  </c:pt>
                  <c:pt idx="8">
                    <c:v>1.00375295765442</c:v>
                  </c:pt>
                </c:numCache>
              </c:numRef>
            </c:plus>
            <c:minus>
              <c:numRef>
                <c:f>Sheet1!$N$38:$V$38</c:f>
                <c:numCache>
                  <c:formatCode>General</c:formatCode>
                  <c:ptCount val="9"/>
                  <c:pt idx="0">
                    <c:v>0.67282687223385995</c:v>
                  </c:pt>
                  <c:pt idx="1">
                    <c:v>0.765960834507875</c:v>
                  </c:pt>
                  <c:pt idx="2">
                    <c:v>0.872774885064872</c:v>
                  </c:pt>
                  <c:pt idx="3">
                    <c:v>0.91272339731158403</c:v>
                  </c:pt>
                  <c:pt idx="4">
                    <c:v>0.98805667853620605</c:v>
                  </c:pt>
                  <c:pt idx="5">
                    <c:v>0.870599793246013</c:v>
                  </c:pt>
                  <c:pt idx="6">
                    <c:v>1.0431299056205801</c:v>
                  </c:pt>
                  <c:pt idx="7">
                    <c:v>1.0112487330029201</c:v>
                  </c:pt>
                  <c:pt idx="8">
                    <c:v>1.003752957654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28:$V$28</c:f>
              <c:strCache>
                <c:ptCount val="9"/>
                <c:pt idx="0">
                  <c:v>Day 10</c:v>
                </c:pt>
                <c:pt idx="1">
                  <c:v>Day 14</c:v>
                </c:pt>
                <c:pt idx="2">
                  <c:v>Day 17</c:v>
                </c:pt>
                <c:pt idx="3">
                  <c:v>Day 21</c:v>
                </c:pt>
                <c:pt idx="4">
                  <c:v>Day 24</c:v>
                </c:pt>
                <c:pt idx="5">
                  <c:v>Day 28</c:v>
                </c:pt>
                <c:pt idx="6">
                  <c:v>Day 31</c:v>
                </c:pt>
                <c:pt idx="7">
                  <c:v>Day 34</c:v>
                </c:pt>
                <c:pt idx="8">
                  <c:v>Day 38</c:v>
                </c:pt>
              </c:strCache>
            </c:strRef>
          </c:cat>
          <c:val>
            <c:numRef>
              <c:f>Sheet1!$N$33:$V$33</c:f>
              <c:numCache>
                <c:formatCode>General</c:formatCode>
                <c:ptCount val="9"/>
                <c:pt idx="0">
                  <c:v>18.488</c:v>
                </c:pt>
                <c:pt idx="1">
                  <c:v>18.692</c:v>
                </c:pt>
                <c:pt idx="2">
                  <c:v>18.687999999999999</c:v>
                </c:pt>
                <c:pt idx="3">
                  <c:v>18.995999999999999</c:v>
                </c:pt>
                <c:pt idx="4">
                  <c:v>19.402000000000001</c:v>
                </c:pt>
                <c:pt idx="5">
                  <c:v>19.044</c:v>
                </c:pt>
                <c:pt idx="6">
                  <c:v>19.78</c:v>
                </c:pt>
                <c:pt idx="7">
                  <c:v>20.103999999999999</c:v>
                </c:pt>
                <c:pt idx="8">
                  <c:v>20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5D2-0D41-A71A-D88D049E0E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3132832"/>
        <c:axId val="353133392"/>
      </c:lineChart>
      <c:catAx>
        <c:axId val="3531328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200" b="1" i="0" u="none" strike="noStrike" kern="1200" baseline="0">
                    <a:solidFill>
                      <a:schemeClr val="tx1"/>
                    </a:solidFill>
                    <a:latin typeface="Helvetica" pitchFamily="2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Helvetica" pitchFamily="2" charset="0"/>
                  </a:rPr>
                  <a:t>Days after inoculation</a:t>
                </a:r>
                <a:endParaRPr lang="ja-JP" sz="1200" b="1">
                  <a:solidFill>
                    <a:schemeClr val="tx1"/>
                  </a:solidFill>
                  <a:latin typeface="Helvetica" pitchFamily="2" charset="0"/>
                </a:endParaRPr>
              </a:p>
            </c:rich>
          </c:tx>
          <c:layout>
            <c:manualLayout>
              <c:xMode val="edge"/>
              <c:yMode val="edge"/>
              <c:x val="0.42346237970253697"/>
              <c:y val="0.927777777777778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zh-CN" sz="1200" b="1" i="0" u="none" strike="noStrike" kern="1200" baseline="0">
                  <a:solidFill>
                    <a:schemeClr val="tx1"/>
                  </a:solidFill>
                  <a:latin typeface="Helvetica" pitchFamily="2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53133392"/>
        <c:crosses val="autoZero"/>
        <c:auto val="1"/>
        <c:lblAlgn val="ctr"/>
        <c:lblOffset val="100"/>
        <c:noMultiLvlLbl val="0"/>
      </c:catAx>
      <c:valAx>
        <c:axId val="353133392"/>
        <c:scaling>
          <c:orientation val="minMax"/>
          <c:max val="25"/>
          <c:min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1" i="0" u="none" strike="noStrike" kern="1200" baseline="0">
                    <a:solidFill>
                      <a:schemeClr val="tx1"/>
                    </a:solidFill>
                    <a:latin typeface="Helvetica" pitchFamily="2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Helvetica" pitchFamily="2" charset="0"/>
                  </a:rPr>
                  <a:t>Body Weight (g)</a:t>
                </a:r>
                <a:endParaRPr lang="ja-JP" sz="1200" b="1">
                  <a:solidFill>
                    <a:schemeClr val="tx1"/>
                  </a:solidFill>
                  <a:latin typeface="Helvetica" pitchFamily="2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1" i="0" u="none" strike="noStrike" kern="1200" baseline="0">
                  <a:solidFill>
                    <a:schemeClr val="tx1"/>
                  </a:solidFill>
                  <a:latin typeface="Helvetica" pitchFamily="2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531328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7266601049868799"/>
          <c:y val="0.49444444444444402"/>
          <c:w val="0.18705621172353501"/>
          <c:h val="0.20694663167104099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zh-CN" sz="1400" b="1" i="0" u="none" strike="noStrike" kern="1200" spc="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altLang="ja-JP" b="1" i="1" dirty="0">
                <a:solidFill>
                  <a:schemeClr val="tx1"/>
                </a:solidFill>
                <a:latin typeface="Helvetica" pitchFamily="2" charset="0"/>
              </a:rPr>
              <a:t>HBZ</a:t>
            </a:r>
            <a:r>
              <a:rPr lang="en-US" altLang="ja-JP" b="1" dirty="0">
                <a:solidFill>
                  <a:schemeClr val="tx1"/>
                </a:solidFill>
                <a:latin typeface="Helvetica" pitchFamily="2" charset="0"/>
              </a:rPr>
              <a:t> expression</a:t>
            </a:r>
            <a:r>
              <a:rPr lang="en-US" altLang="ja-JP" b="1" baseline="0" dirty="0">
                <a:solidFill>
                  <a:schemeClr val="tx1"/>
                </a:solidFill>
                <a:latin typeface="Helvetica" pitchFamily="2" charset="0"/>
              </a:rPr>
              <a:t> in TL-Om1 with IMiDs treatment</a:t>
            </a:r>
            <a:endParaRPr lang="ja-JP" altLang="en-US" b="1">
              <a:solidFill>
                <a:schemeClr val="tx1"/>
              </a:solidFill>
              <a:latin typeface="Helvetica" pitchFamily="2" charset="0"/>
            </a:endParaRPr>
          </a:p>
        </c:rich>
      </c:tx>
      <c:layout>
        <c:manualLayout>
          <c:xMode val="edge"/>
          <c:yMode val="edge"/>
          <c:x val="0.33675876245557801"/>
          <c:y val="3.50877192982455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400" b="1" i="0" u="none" strike="noStrike" kern="1200" spc="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4423501265881606E-2"/>
          <c:y val="0.122536010749852"/>
          <c:w val="0.85805437484031299"/>
          <c:h val="0.70504514686860298"/>
        </c:manualLayout>
      </c:layout>
      <c:lineChart>
        <c:grouping val="standard"/>
        <c:varyColors val="0"/>
        <c:ser>
          <c:idx val="0"/>
          <c:order val="0"/>
          <c:tx>
            <c:strRef>
              <c:f>Sheet1!$F$50</c:f>
              <c:strCache>
                <c:ptCount val="1"/>
                <c:pt idx="0">
                  <c:v>LEN</c:v>
                </c:pt>
              </c:strCache>
            </c:strRef>
          </c:tx>
          <c:spPr>
            <a:ln w="28575" cap="rnd">
              <a:solidFill>
                <a:srgbClr val="0432FF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L$50:$P$50</c:f>
                <c:numCache>
                  <c:formatCode>General</c:formatCode>
                  <c:ptCount val="5"/>
                  <c:pt idx="0">
                    <c:v>0.105138404497469</c:v>
                  </c:pt>
                  <c:pt idx="1">
                    <c:v>0.105638638495045</c:v>
                  </c:pt>
                  <c:pt idx="2">
                    <c:v>2.34032742802525E-2</c:v>
                  </c:pt>
                  <c:pt idx="3">
                    <c:v>1.99915009221543E-2</c:v>
                  </c:pt>
                  <c:pt idx="4">
                    <c:v>3.1635041587473801E-2</c:v>
                  </c:pt>
                </c:numCache>
              </c:numRef>
            </c:plus>
            <c:minus>
              <c:numRef>
                <c:f>Sheet1!$L$50:$P$50</c:f>
                <c:numCache>
                  <c:formatCode>General</c:formatCode>
                  <c:ptCount val="5"/>
                  <c:pt idx="0">
                    <c:v>0.105138404497469</c:v>
                  </c:pt>
                  <c:pt idx="1">
                    <c:v>0.105638638495045</c:v>
                  </c:pt>
                  <c:pt idx="2">
                    <c:v>2.34032742802525E-2</c:v>
                  </c:pt>
                  <c:pt idx="3">
                    <c:v>1.99915009221543E-2</c:v>
                  </c:pt>
                  <c:pt idx="4">
                    <c:v>3.16350415874738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G$49:$K$49</c:f>
              <c:numCache>
                <c:formatCode>General</c:formatCode>
                <c:ptCount val="5"/>
                <c:pt idx="0">
                  <c:v>0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</c:numCache>
            </c:numRef>
          </c:cat>
          <c:val>
            <c:numRef>
              <c:f>Sheet1!$G$50:$K$50</c:f>
              <c:numCache>
                <c:formatCode>0.0000</c:formatCode>
                <c:ptCount val="5"/>
                <c:pt idx="0" formatCode="General">
                  <c:v>1</c:v>
                </c:pt>
                <c:pt idx="1">
                  <c:v>1.0810347398240601</c:v>
                </c:pt>
                <c:pt idx="2">
                  <c:v>0.89809154614581799</c:v>
                </c:pt>
                <c:pt idx="3">
                  <c:v>1.09527359475175</c:v>
                </c:pt>
                <c:pt idx="4">
                  <c:v>1.1393320411510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9C4-7E4D-B2C3-792F3C968E89}"/>
            </c:ext>
          </c:extLst>
        </c:ser>
        <c:ser>
          <c:idx val="1"/>
          <c:order val="1"/>
          <c:tx>
            <c:strRef>
              <c:f>Sheet1!$F$51</c:f>
              <c:strCache>
                <c:ptCount val="1"/>
                <c:pt idx="0">
                  <c:v>POM</c:v>
                </c:pt>
              </c:strCache>
            </c:strRef>
          </c:tx>
          <c:spPr>
            <a:ln w="28575" cap="rnd">
              <a:solidFill>
                <a:srgbClr val="FC6708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L$51:$P$51</c:f>
                <c:numCache>
                  <c:formatCode>General</c:formatCode>
                  <c:ptCount val="5"/>
                  <c:pt idx="0">
                    <c:v>0.105138404497469</c:v>
                  </c:pt>
                  <c:pt idx="1">
                    <c:v>3.3188280968056302E-2</c:v>
                  </c:pt>
                  <c:pt idx="2">
                    <c:v>6.15541215667611E-2</c:v>
                  </c:pt>
                  <c:pt idx="3">
                    <c:v>3.5333620739161499E-2</c:v>
                  </c:pt>
                  <c:pt idx="4">
                    <c:v>3.3867560810232698E-2</c:v>
                  </c:pt>
                </c:numCache>
              </c:numRef>
            </c:plus>
            <c:minus>
              <c:numRef>
                <c:f>Sheet1!$L$51:$P$51</c:f>
                <c:numCache>
                  <c:formatCode>General</c:formatCode>
                  <c:ptCount val="5"/>
                  <c:pt idx="0">
                    <c:v>0.105138404497469</c:v>
                  </c:pt>
                  <c:pt idx="1">
                    <c:v>3.3188280968056302E-2</c:v>
                  </c:pt>
                  <c:pt idx="2">
                    <c:v>6.15541215667611E-2</c:v>
                  </c:pt>
                  <c:pt idx="3">
                    <c:v>3.5333620739161499E-2</c:v>
                  </c:pt>
                  <c:pt idx="4">
                    <c:v>3.38675608102326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G$49:$K$49</c:f>
              <c:numCache>
                <c:formatCode>General</c:formatCode>
                <c:ptCount val="5"/>
                <c:pt idx="0">
                  <c:v>0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</c:numCache>
            </c:numRef>
          </c:cat>
          <c:val>
            <c:numRef>
              <c:f>Sheet1!$G$51:$K$51</c:f>
              <c:numCache>
                <c:formatCode>0.0000</c:formatCode>
                <c:ptCount val="5"/>
                <c:pt idx="0" formatCode="General">
                  <c:v>1</c:v>
                </c:pt>
                <c:pt idx="1">
                  <c:v>1.0509915014164299</c:v>
                </c:pt>
                <c:pt idx="2">
                  <c:v>0.88899657074698102</c:v>
                </c:pt>
                <c:pt idx="3">
                  <c:v>0.88802743402415396</c:v>
                </c:pt>
                <c:pt idx="4">
                  <c:v>0.982928283882510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9C4-7E4D-B2C3-792F3C968E89}"/>
            </c:ext>
          </c:extLst>
        </c:ser>
        <c:ser>
          <c:idx val="2"/>
          <c:order val="2"/>
          <c:tx>
            <c:strRef>
              <c:f>Sheet1!$F$52</c:f>
              <c:strCache>
                <c:ptCount val="1"/>
                <c:pt idx="0">
                  <c:v>IBE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L$52:$P$52</c:f>
                <c:numCache>
                  <c:formatCode>General</c:formatCode>
                  <c:ptCount val="5"/>
                  <c:pt idx="0">
                    <c:v>0.105138404497469</c:v>
                  </c:pt>
                  <c:pt idx="1">
                    <c:v>3.4482267253093203E-2</c:v>
                  </c:pt>
                  <c:pt idx="2">
                    <c:v>6.2717050455442999E-2</c:v>
                  </c:pt>
                  <c:pt idx="3">
                    <c:v>6.3853582889129401E-2</c:v>
                  </c:pt>
                  <c:pt idx="4">
                    <c:v>4.7104809109752399E-2</c:v>
                  </c:pt>
                </c:numCache>
              </c:numRef>
            </c:plus>
            <c:minus>
              <c:numRef>
                <c:f>Sheet1!$L$52:$P$52</c:f>
                <c:numCache>
                  <c:formatCode>General</c:formatCode>
                  <c:ptCount val="5"/>
                  <c:pt idx="0">
                    <c:v>0.105138404497469</c:v>
                  </c:pt>
                  <c:pt idx="1">
                    <c:v>3.4482267253093203E-2</c:v>
                  </c:pt>
                  <c:pt idx="2">
                    <c:v>6.2717050455442999E-2</c:v>
                  </c:pt>
                  <c:pt idx="3">
                    <c:v>6.3853582889129401E-2</c:v>
                  </c:pt>
                  <c:pt idx="4">
                    <c:v>4.71048091097523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G$49:$K$49</c:f>
              <c:numCache>
                <c:formatCode>General</c:formatCode>
                <c:ptCount val="5"/>
                <c:pt idx="0">
                  <c:v>0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</c:numCache>
            </c:numRef>
          </c:cat>
          <c:val>
            <c:numRef>
              <c:f>Sheet1!$G$52:$K$52</c:f>
              <c:numCache>
                <c:formatCode>0.0000</c:formatCode>
                <c:ptCount val="5"/>
                <c:pt idx="0" formatCode="General">
                  <c:v>1</c:v>
                </c:pt>
                <c:pt idx="1">
                  <c:v>0.98516475324288</c:v>
                </c:pt>
                <c:pt idx="2">
                  <c:v>0.99977635306396295</c:v>
                </c:pt>
                <c:pt idx="3">
                  <c:v>1.0518860891605799</c:v>
                </c:pt>
                <c:pt idx="4">
                  <c:v>0.925972864171760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9C4-7E4D-B2C3-792F3C968E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15039904"/>
        <c:axId val="1215041552"/>
      </c:lineChart>
      <c:catAx>
        <c:axId val="12150399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400" b="0" i="0" u="none" strike="noStrike" kern="1200" baseline="0">
                    <a:solidFill>
                      <a:schemeClr val="tx1"/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400" b="0" dirty="0">
                    <a:solidFill>
                      <a:schemeClr val="tx1"/>
                    </a:solidFill>
                    <a:latin typeface="Helvetica" pitchFamily="2" charset="0"/>
                  </a:rPr>
                  <a:t>Concentration (μM)</a:t>
                </a:r>
                <a:endParaRPr lang="ja-JP" altLang="en-US" sz="1400" b="0">
                  <a:solidFill>
                    <a:schemeClr val="tx1"/>
                  </a:solidFill>
                  <a:latin typeface="Helvetica" pitchFamily="2" charset="0"/>
                </a:endParaRPr>
              </a:p>
            </c:rich>
          </c:tx>
          <c:layout>
            <c:manualLayout>
              <c:xMode val="edge"/>
              <c:yMode val="edge"/>
              <c:x val="0.41863133811813302"/>
              <c:y val="0.909330017958280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zh-CN" sz="1400" b="0" i="0" u="none" strike="noStrike" kern="1200" baseline="0">
                  <a:solidFill>
                    <a:schemeClr val="tx1"/>
                  </a:solidFill>
                  <a:latin typeface="Helvetica" pitchFamily="2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215041552"/>
        <c:crosses val="autoZero"/>
        <c:auto val="1"/>
        <c:lblAlgn val="ctr"/>
        <c:lblOffset val="100"/>
        <c:noMultiLvlLbl val="0"/>
      </c:catAx>
      <c:valAx>
        <c:axId val="1215041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/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200" dirty="0">
                    <a:solidFill>
                      <a:schemeClr val="tx1"/>
                    </a:solidFill>
                    <a:latin typeface="Helvetica" pitchFamily="2" charset="0"/>
                  </a:rPr>
                  <a:t>Relative expression level (% </a:t>
                </a:r>
                <a:r>
                  <a:rPr lang="en-US" altLang="ja-JP" sz="1000" dirty="0">
                    <a:solidFill>
                      <a:schemeClr val="tx1"/>
                    </a:solidFill>
                    <a:latin typeface="Helvetica" pitchFamily="2" charset="0"/>
                  </a:rPr>
                  <a:t>vs Control</a:t>
                </a:r>
                <a:r>
                  <a:rPr lang="en-US" altLang="ja-JP" sz="1200" dirty="0">
                    <a:solidFill>
                      <a:schemeClr val="tx1"/>
                    </a:solidFill>
                    <a:latin typeface="Helvetica" pitchFamily="2" charset="0"/>
                  </a:rPr>
                  <a:t>)</a:t>
                </a:r>
                <a:endParaRPr lang="ja-JP" altLang="en-US" sz="1200">
                  <a:solidFill>
                    <a:schemeClr val="tx1"/>
                  </a:solidFill>
                  <a:latin typeface="Helvetica" pitchFamily="2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/>
                  </a:solidFill>
                  <a:latin typeface="Helvetica" pitchFamily="2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215039904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82546442756602301"/>
          <c:y val="0.454345778548016"/>
          <c:w val="8.6739966883867203E-2"/>
          <c:h val="0.17422876845990101"/>
        </c:manualLayout>
      </c:layout>
      <c:overlay val="0"/>
      <c:spPr>
        <a:solidFill>
          <a:schemeClr val="bg1"/>
        </a:solidFill>
        <a:ln>
          <a:solidFill>
            <a:schemeClr val="bg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lang="zh-CN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9575" cy="496888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12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6039" y="0"/>
            <a:ext cx="2949575" cy="496888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12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229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440865"/>
            <a:ext cx="2949575" cy="496887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b" anchorCtr="0" compatLnSpc="1"/>
          <a:lstStyle>
            <a:lvl1pPr>
              <a:defRPr sz="12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229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6039" y="9440865"/>
            <a:ext cx="2949575" cy="496887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b" anchorCtr="0" compatLnSpc="1"/>
          <a:lstStyle>
            <a:lvl1pPr algn="r">
              <a:defRPr sz="120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fld id="{103E076D-AF97-594A-A633-6AA16D92E57D}" type="slidenum">
              <a:rPr lang="en-US" altLang="ja-JP"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9575" cy="496888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12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638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6039" y="0"/>
            <a:ext cx="2949575" cy="496888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12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609600" y="746125"/>
            <a:ext cx="5588000" cy="37258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</a:ln>
        </p:spPr>
      </p:sp>
      <p:sp>
        <p:nvSpPr>
          <p:cNvPr id="1638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1039" y="4721226"/>
            <a:ext cx="5445125" cy="4471988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639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440865"/>
            <a:ext cx="2949575" cy="496887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b" anchorCtr="0" compatLnSpc="1"/>
          <a:lstStyle>
            <a:lvl1pPr>
              <a:defRPr sz="12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639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6039" y="9440865"/>
            <a:ext cx="2949575" cy="496887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b" anchorCtr="0" compatLnSpc="1"/>
          <a:lstStyle>
            <a:lvl1pPr algn="r">
              <a:defRPr sz="120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fld id="{B5B29BD9-B2CE-EC4A-BE9C-8296E8A2C510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ヒラギノ角ゴ Pro W3" pitchFamily="34" charset="-128"/>
        <a:cs typeface="ヒラギノ角ゴ Pro W3" pitchFamily="34" charset="-128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ヒラギノ角ゴ Pro W3" pitchFamily="34" charset="-128"/>
        <a:cs typeface="ヒラギノ角ゴ Pro W3" pitchFamily="34" charset="-128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ヒラギノ角ゴ Pro W3" pitchFamily="34" charset="-128"/>
        <a:cs typeface="ヒラギノ角ゴ Pro W3" pitchFamily="34" charset="-128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ヒラギノ角ゴ Pro W3" pitchFamily="34" charset="-128"/>
        <a:cs typeface="ヒラギノ角ゴ Pro W3" pitchFamily="34" charset="-128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ヒラギノ角ゴ Pro W3" pitchFamily="34" charset="-128"/>
        <a:cs typeface="ヒラギノ角ゴ Pro W3" pitchFamily="34" charset="-128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2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13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14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What I did first was collecting ATL cell lines as many as possible.</a:t>
            </a:r>
          </a:p>
          <a:p>
            <a:r>
              <a:rPr kumimoji="1" lang="en-US" altLang="ja-JP" dirty="0"/>
              <a:t>We knew lenalidomide exerts its growth inhibitory effects on some MM cell lines.</a:t>
            </a:r>
          </a:p>
          <a:p>
            <a:r>
              <a:rPr kumimoji="1" lang="ja-JP" altLang="en-US"/>
              <a:t>クリック</a:t>
            </a:r>
            <a:r>
              <a:rPr kumimoji="1" lang="en-US" altLang="ja-JP" dirty="0"/>
              <a:t>1</a:t>
            </a:r>
          </a:p>
          <a:p>
            <a:r>
              <a:rPr kumimoji="1" lang="en-US" altLang="ja-JP" dirty="0"/>
              <a:t>We employed two MM cells as controls</a:t>
            </a:r>
            <a:r>
              <a:rPr kumimoji="1" lang="en-US" altLang="ja-JP" baseline="0" dirty="0"/>
              <a:t> namely</a:t>
            </a:r>
            <a:r>
              <a:rPr kumimoji="1" lang="en-US" altLang="ja-JP" dirty="0"/>
              <a:t> lenalidomide resistant MM1 and sensitive MM2.</a:t>
            </a:r>
          </a:p>
          <a:p>
            <a:r>
              <a:rPr kumimoji="1" lang="en-US" altLang="ja-JP" dirty="0"/>
              <a:t>We always used them as the negative or positive controls of lenalidomide efficacy.</a:t>
            </a:r>
          </a:p>
          <a:p>
            <a:r>
              <a:rPr kumimoji="1" lang="ja-JP" altLang="en-US"/>
              <a:t>クリック</a:t>
            </a:r>
            <a:r>
              <a:rPr kumimoji="1" lang="en-US" altLang="ja-JP" dirty="0"/>
              <a:t>2</a:t>
            </a:r>
          </a:p>
          <a:p>
            <a:r>
              <a:rPr kumimoji="1" lang="en-US" altLang="ja-JP" dirty="0"/>
              <a:t>Among 13 different ATL cells and 5 non-ATL cells, we found that one cell line ATL1</a:t>
            </a:r>
            <a:r>
              <a:rPr kumimoji="1" lang="en-US" altLang="ja-JP" baseline="0" dirty="0"/>
              <a:t> responded well to lenalidomide treatment.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3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What I did first was collecting ATL cell lines as many as possible.</a:t>
            </a:r>
          </a:p>
          <a:p>
            <a:r>
              <a:rPr kumimoji="1" lang="en-US" altLang="ja-JP" dirty="0"/>
              <a:t>We knew lenalidomide exerts its growth inhibitory effects on some MM cell lines.</a:t>
            </a:r>
          </a:p>
          <a:p>
            <a:r>
              <a:rPr kumimoji="1" lang="ja-JP" altLang="en-US"/>
              <a:t>クリック</a:t>
            </a:r>
            <a:r>
              <a:rPr kumimoji="1" lang="en-US" altLang="ja-JP" dirty="0"/>
              <a:t>1</a:t>
            </a:r>
          </a:p>
          <a:p>
            <a:r>
              <a:rPr kumimoji="1" lang="en-US" altLang="ja-JP" dirty="0"/>
              <a:t>We employed two MM cells as controls</a:t>
            </a:r>
            <a:r>
              <a:rPr kumimoji="1" lang="en-US" altLang="ja-JP" baseline="0" dirty="0"/>
              <a:t> namely</a:t>
            </a:r>
            <a:r>
              <a:rPr kumimoji="1" lang="en-US" altLang="ja-JP" dirty="0"/>
              <a:t> lenalidomide resistant MM1 and sensitive MM2.</a:t>
            </a:r>
          </a:p>
          <a:p>
            <a:r>
              <a:rPr kumimoji="1" lang="en-US" altLang="ja-JP" dirty="0"/>
              <a:t>We always used them as the negative or positive controls of lenalidomide efficacy.</a:t>
            </a:r>
          </a:p>
          <a:p>
            <a:r>
              <a:rPr kumimoji="1" lang="ja-JP" altLang="en-US"/>
              <a:t>クリック</a:t>
            </a:r>
            <a:r>
              <a:rPr kumimoji="1" lang="en-US" altLang="ja-JP" dirty="0"/>
              <a:t>2</a:t>
            </a:r>
          </a:p>
          <a:p>
            <a:r>
              <a:rPr kumimoji="1" lang="en-US" altLang="ja-JP" dirty="0"/>
              <a:t>Among 13 different ATL cells and 5 non-ATL cells, we found that one cell line ATL1</a:t>
            </a:r>
            <a:r>
              <a:rPr kumimoji="1" lang="en-US" altLang="ja-JP" baseline="0" dirty="0"/>
              <a:t> responded well to lenalidomide treatment.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4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5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6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7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8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11</a:t>
            </a:fld>
            <a:endParaRPr lang="en-US" altLang="ja-JP"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he summary</a:t>
            </a:r>
            <a:r>
              <a:rPr kumimoji="1" lang="en-US" altLang="ja-JP" baseline="0" dirty="0"/>
              <a:t> in this chapter is </a:t>
            </a:r>
            <a:r>
              <a:rPr kumimoji="1" lang="en-US" altLang="ja-JP" dirty="0"/>
              <a:t>as follows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B29BD9-B2CE-EC4A-BE9C-8296E8A2C510}" type="slidenum">
              <a:rPr lang="en-US" altLang="ja-JP" smtClean="0"/>
              <a:t>12</a:t>
            </a:fld>
            <a:endParaRPr lang="en-US" altLang="ja-JP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1184D7-BBCB-154F-A420-0A462AD7302D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C0BBE25-9F3B-8C4B-ADD0-60C280069C74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68790" y="274638"/>
            <a:ext cx="2316362" cy="58801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82991" cy="58801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1253D4-9036-0C48-991C-308B950F07B1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228317-F94E-1D47-BC6E-5CE6D1FDE652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3F1A41-8DE3-2142-90EA-D87BB3E79E8A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26852" y="1628776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241727" y="1628776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A192AA1-53CC-DB4F-91FD-E0913F73CB12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1B31AF4-F547-E749-9535-04E46B50F60B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8C06659-4146-2A4D-8F8B-6ED53CAF7A99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066CA8B-4ED4-F942-B030-359A037A7A1C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FB9AE2C-684B-A744-BD8A-5A70179CE55D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B777076-1436-144A-9E48-56048391B060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27050" y="1628775"/>
            <a:ext cx="9258300" cy="4525963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5225"/>
            <a:ext cx="2400300" cy="47625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14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5225"/>
            <a:ext cx="3257550" cy="47625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>
              <a:defRPr sz="1400" b="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886700" y="6524625"/>
            <a:ext cx="2400300" cy="47625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defRPr>
            </a:lvl1pPr>
          </a:lstStyle>
          <a:p>
            <a:fld id="{EE42E01E-A461-A340-9E41-CBE34B6D8EEA}" type="slidenum">
              <a:rPr lang="en-US" altLang="ja-JP"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MS PGothic" panose="020B0600070205080204" pitchFamily="34" charset="-128"/>
          <a:cs typeface="MS PGothic" panose="020B0600070205080204" pitchFamily="34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tags" Target="../tags/tag17.xml"/><Relationship Id="rId7" Type="http://schemas.openxmlformats.org/officeDocument/2006/relationships/image" Target="../media/image24.png"/><Relationship Id="rId2" Type="http://schemas.openxmlformats.org/officeDocument/2006/relationships/tags" Target="../tags/tag16.xml"/><Relationship Id="rId1" Type="http://schemas.openxmlformats.org/officeDocument/2006/relationships/tags" Target="../tags/tag15.xml"/><Relationship Id="rId6" Type="http://schemas.openxmlformats.org/officeDocument/2006/relationships/slideLayout" Target="../slideLayouts/slideLayout7.xml"/><Relationship Id="rId5" Type="http://schemas.openxmlformats.org/officeDocument/2006/relationships/tags" Target="../tags/tag19.xml"/><Relationship Id="rId4" Type="http://schemas.openxmlformats.org/officeDocument/2006/relationships/tags" Target="../tags/tag18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notesSlide" Target="../notesSlides/notesSlide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tags" Target="../tags/tag11.xml"/><Relationship Id="rId13" Type="http://schemas.openxmlformats.org/officeDocument/2006/relationships/image" Target="../media/image15.png"/><Relationship Id="rId18" Type="http://schemas.openxmlformats.org/officeDocument/2006/relationships/image" Target="../media/image20.png"/><Relationship Id="rId3" Type="http://schemas.openxmlformats.org/officeDocument/2006/relationships/tags" Target="../tags/tag6.xml"/><Relationship Id="rId21" Type="http://schemas.openxmlformats.org/officeDocument/2006/relationships/image" Target="../media/image23.png"/><Relationship Id="rId7" Type="http://schemas.openxmlformats.org/officeDocument/2006/relationships/tags" Target="../tags/tag10.xml"/><Relationship Id="rId12" Type="http://schemas.openxmlformats.org/officeDocument/2006/relationships/slideLayout" Target="../slideLayouts/slideLayout7.xml"/><Relationship Id="rId17" Type="http://schemas.openxmlformats.org/officeDocument/2006/relationships/image" Target="../media/image19.png"/><Relationship Id="rId2" Type="http://schemas.openxmlformats.org/officeDocument/2006/relationships/tags" Target="../tags/tag5.xml"/><Relationship Id="rId16" Type="http://schemas.openxmlformats.org/officeDocument/2006/relationships/image" Target="../media/image18.png"/><Relationship Id="rId20" Type="http://schemas.openxmlformats.org/officeDocument/2006/relationships/image" Target="../media/image22.png"/><Relationship Id="rId1" Type="http://schemas.openxmlformats.org/officeDocument/2006/relationships/tags" Target="../tags/tag4.xml"/><Relationship Id="rId6" Type="http://schemas.openxmlformats.org/officeDocument/2006/relationships/tags" Target="../tags/tag9.xml"/><Relationship Id="rId11" Type="http://schemas.openxmlformats.org/officeDocument/2006/relationships/tags" Target="../tags/tag14.xml"/><Relationship Id="rId5" Type="http://schemas.openxmlformats.org/officeDocument/2006/relationships/tags" Target="../tags/tag8.xml"/><Relationship Id="rId15" Type="http://schemas.openxmlformats.org/officeDocument/2006/relationships/image" Target="../media/image17.png"/><Relationship Id="rId10" Type="http://schemas.openxmlformats.org/officeDocument/2006/relationships/tags" Target="../tags/tag13.xml"/><Relationship Id="rId19" Type="http://schemas.openxmlformats.org/officeDocument/2006/relationships/image" Target="../media/image21.png"/><Relationship Id="rId4" Type="http://schemas.openxmlformats.org/officeDocument/2006/relationships/tags" Target="../tags/tag7.xml"/><Relationship Id="rId9" Type="http://schemas.openxmlformats.org/officeDocument/2006/relationships/tags" Target="../tags/tag12.xml"/><Relationship Id="rId1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5719564" y="620688"/>
            <a:ext cx="3785593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GB" altLang="ja-JP" sz="1200" dirty="0">
                <a:latin typeface="Helvetica" pitchFamily="2" charset="0"/>
              </a:rPr>
              <a:t>Table criteria: 1] origin of the cell; 2] cell lineage; 3] Tax-expression and 4] infectivity (ATL or HTLV-1-transformed cells only). </a:t>
            </a:r>
          </a:p>
          <a:p>
            <a:endParaRPr kumimoji="1" lang="en-GB" altLang="ja-JP" sz="1200" dirty="0">
              <a:latin typeface="Helvetica" pitchFamily="2" charset="0"/>
            </a:endParaRPr>
          </a:p>
          <a:p>
            <a:r>
              <a:rPr kumimoji="1" lang="en-GB" altLang="ja-JP" sz="1200" dirty="0">
                <a:latin typeface="Helvetica" pitchFamily="2" charset="0"/>
              </a:rPr>
              <a:t>Ten ATL-patient derived and three HTLV-1 transformed cell lines, three HTLV-1 negative T-cell or monocyte malignant cell lines and two multiple myeloma cell lines (NCI-H929 as responsive and RPMI-8226 as </a:t>
            </a:r>
            <a:r>
              <a:rPr kumimoji="1" lang="en-GB" altLang="ja-JP" sz="1200" dirty="0" err="1">
                <a:latin typeface="Helvetica" pitchFamily="2" charset="0"/>
              </a:rPr>
              <a:t>resitant</a:t>
            </a:r>
            <a:r>
              <a:rPr kumimoji="1" lang="en-GB" altLang="ja-JP" sz="1200" dirty="0">
                <a:latin typeface="Helvetica" pitchFamily="2" charset="0"/>
              </a:rPr>
              <a:t> controls respectively) were selected for lenalidomide efficacy study. ATL cell lines HuT102, ED40515, S1T, OATL4, and OATL9, HTLV-1 transformed cell lines MT-2, MT-4 and C8166, PTCL cell line HuT78, other T-cell </a:t>
            </a:r>
            <a:r>
              <a:rPr kumimoji="1" lang="en-GB" altLang="ja-JP" sz="1200" dirty="0" err="1">
                <a:latin typeface="Helvetica" pitchFamily="2" charset="0"/>
              </a:rPr>
              <a:t>Jurkat</a:t>
            </a:r>
            <a:r>
              <a:rPr kumimoji="1" lang="en-GB" altLang="ja-JP" sz="1200" dirty="0">
                <a:latin typeface="Helvetica" pitchFamily="2" charset="0"/>
              </a:rPr>
              <a:t>, MOLT4 are laboratory stocks (Dr. Hidekatsu Iha, Oita University, and Prof. Kazuhiro </a:t>
            </a:r>
            <a:r>
              <a:rPr kumimoji="1" lang="en-GB" altLang="ja-JP" sz="1200" dirty="0" err="1">
                <a:latin typeface="Helvetica" pitchFamily="2" charset="0"/>
              </a:rPr>
              <a:t>Morishita</a:t>
            </a:r>
            <a:r>
              <a:rPr kumimoji="1" lang="en-GB" altLang="ja-JP" sz="1200" dirty="0">
                <a:latin typeface="Helvetica" pitchFamily="2" charset="0"/>
              </a:rPr>
              <a:t>, University of Miyazaki). ATL cell lines ST1, KOB, KK1 and SO4 are kind gift from Dr. </a:t>
            </a:r>
            <a:r>
              <a:rPr kumimoji="1" lang="en-GB" altLang="ja-JP" sz="1200" dirty="0" err="1">
                <a:latin typeface="Helvetica" pitchFamily="2" charset="0"/>
              </a:rPr>
              <a:t>Hiroo</a:t>
            </a:r>
            <a:r>
              <a:rPr kumimoji="1" lang="en-GB" altLang="ja-JP" sz="1200" dirty="0">
                <a:latin typeface="Helvetica" pitchFamily="2" charset="0"/>
              </a:rPr>
              <a:t> Hasegawa, Nagasaki University). NCI-H929 and RPMI-8226 were purchased from American Type Culture Collection (ATCC: Manassas, VA, USA).</a:t>
            </a:r>
            <a:endParaRPr kumimoji="1" lang="ja-JP" altLang="en-US" sz="1200">
              <a:latin typeface="Helvetica" pitchFamily="2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956" y="548680"/>
            <a:ext cx="5302941" cy="5400600"/>
          </a:xfrm>
          <a:prstGeom prst="rect">
            <a:avLst/>
          </a:prstGeom>
        </p:spPr>
      </p:pic>
      <p:sp>
        <p:nvSpPr>
          <p:cNvPr id="4" name="Rectangle 17"/>
          <p:cNvSpPr>
            <a:spLocks noChangeArrowheads="1"/>
          </p:cNvSpPr>
          <p:nvPr/>
        </p:nvSpPr>
        <p:spPr bwMode="auto">
          <a:xfrm>
            <a:off x="0" y="108494"/>
            <a:ext cx="9772599" cy="336246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2000" b="1" dirty="0">
                <a:latin typeface="Helvetica" pitchFamily="2" charset="0"/>
              </a:rPr>
              <a:t>Suppl.1 Cell line information</a:t>
            </a:r>
            <a:endParaRPr lang="ja-JP" altLang="en-US" sz="2000" b="1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103505" y="2705100"/>
            <a:ext cx="5175250" cy="308864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5431790" y="2943860"/>
            <a:ext cx="4755515" cy="2864485"/>
          </a:xfrm>
          <a:prstGeom prst="rect">
            <a:avLst/>
          </a:prstGeom>
        </p:spPr>
      </p:pic>
      <p:sp>
        <p:nvSpPr>
          <p:cNvPr id="17" name="Rectangle 17"/>
          <p:cNvSpPr>
            <a:spLocks noChangeArrowheads="1"/>
          </p:cNvSpPr>
          <p:nvPr>
            <p:custDataLst>
              <p:tags r:id="rId3"/>
            </p:custDataLst>
          </p:nvPr>
        </p:nvSpPr>
        <p:spPr bwMode="auto">
          <a:xfrm>
            <a:off x="247015" y="1917065"/>
            <a:ext cx="4499610" cy="55308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800" b="1" dirty="0">
                <a:latin typeface="Helvetica" pitchFamily="2" charset="0"/>
              </a:rPr>
              <a:t>B. Comparison of ED40515 with HuT102</a:t>
            </a:r>
          </a:p>
        </p:txBody>
      </p:sp>
      <p:sp>
        <p:nvSpPr>
          <p:cNvPr id="5" name="Rectangle 17"/>
          <p:cNvSpPr>
            <a:spLocks noChangeArrowheads="1"/>
          </p:cNvSpPr>
          <p:nvPr>
            <p:custDataLst>
              <p:tags r:id="rId4"/>
            </p:custDataLst>
          </p:nvPr>
        </p:nvSpPr>
        <p:spPr bwMode="auto">
          <a:xfrm>
            <a:off x="5647631" y="1844555"/>
            <a:ext cx="4063380" cy="55308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800" b="1" dirty="0">
                <a:latin typeface="Helvetica" pitchFamily="2" charset="0"/>
              </a:rPr>
              <a:t>C. Comparison of ED40515 with OATL4</a:t>
            </a:r>
          </a:p>
        </p:txBody>
      </p:sp>
      <p:sp>
        <p:nvSpPr>
          <p:cNvPr id="4" name="Rectangle 17">
            <a:extLst>
              <a:ext uri="{FF2B5EF4-FFF2-40B4-BE49-F238E27FC236}">
                <a16:creationId xmlns:a16="http://schemas.microsoft.com/office/drawing/2014/main" id="{C9849325-458F-48AC-A224-193DB44118D6}"/>
              </a:ext>
            </a:extLst>
          </p:cNvPr>
          <p:cNvSpPr>
            <a:spLocks noChangeArrowheads="1"/>
          </p:cNvSpPr>
          <p:nvPr>
            <p:custDataLst>
              <p:tags r:id="rId5"/>
            </p:custDataLst>
          </p:nvPr>
        </p:nvSpPr>
        <p:spPr bwMode="auto">
          <a:xfrm>
            <a:off x="0" y="44624"/>
            <a:ext cx="10287000" cy="109156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t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.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 1</a:t>
            </a:r>
            <a:r>
              <a:rPr lang="en-US" altLang="ja-JP" sz="2000" b="1" dirty="0">
                <a:solidFill>
                  <a:srgbClr val="008F00"/>
                </a:solidFill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4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. </a:t>
            </a: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</a:rPr>
              <a:t>LEN-induced gene expression profiles of ED40515, and the comparison of ED40515 with HuT102 and OATL4</a:t>
            </a:r>
          </a:p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</a:rPr>
              <a:t> </a:t>
            </a:r>
            <a:endParaRPr lang="zh-CN" altLang="en-US" sz="2000" dirty="0">
              <a:solidFill>
                <a:schemeClr val="tx2">
                  <a:lumMod val="50000"/>
                </a:schemeClr>
              </a:solidFill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11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10" name="Rectangle 17"/>
          <p:cNvSpPr>
            <a:spLocks noChangeArrowheads="1"/>
          </p:cNvSpPr>
          <p:nvPr/>
        </p:nvSpPr>
        <p:spPr bwMode="auto">
          <a:xfrm>
            <a:off x="174948" y="180441"/>
            <a:ext cx="9319964" cy="398780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.1</a:t>
            </a:r>
            <a:r>
              <a:rPr lang="en-US" altLang="ja-JP" sz="2000" b="1" dirty="0">
                <a:solidFill>
                  <a:srgbClr val="008F00"/>
                </a:solidFill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5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. Average mice body weights of LEN-treatment mice  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  <p:graphicFrame>
        <p:nvGraphicFramePr>
          <p:cNvPr id="6" name="グラフ 5"/>
          <p:cNvGraphicFramePr/>
          <p:nvPr/>
        </p:nvGraphicFramePr>
        <p:xfrm>
          <a:off x="571500" y="1143000"/>
          <a:ext cx="914400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12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10" name="Rectangle 17"/>
          <p:cNvSpPr>
            <a:spLocks noChangeArrowheads="1"/>
          </p:cNvSpPr>
          <p:nvPr/>
        </p:nvSpPr>
        <p:spPr bwMode="auto">
          <a:xfrm>
            <a:off x="576064" y="117297"/>
            <a:ext cx="9319964" cy="398780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e 1</a:t>
            </a:r>
            <a:r>
              <a:rPr lang="en-US" altLang="ja-JP" sz="2000" b="1" dirty="0">
                <a:solidFill>
                  <a:srgbClr val="008F00"/>
                </a:solidFill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6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. Cell-titer values and statistical significance in Fig. 7A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〜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D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327076" y="3564237"/>
            <a:ext cx="1846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HuT102 (Tax</a:t>
            </a:r>
            <a:r>
              <a:rPr kumimoji="1" lang="en-US" altLang="ja-JP" sz="1600" b="1" baseline="30000" dirty="0">
                <a:latin typeface="Helvetica" pitchFamily="2" charset="0"/>
              </a:rPr>
              <a:t>+</a:t>
            </a:r>
            <a:r>
              <a:rPr kumimoji="1" lang="en-US" altLang="ja-JP" sz="1600" b="1" dirty="0">
                <a:latin typeface="Helvetica" pitchFamily="2" charset="0"/>
              </a:rPr>
              <a:t>)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953253" y="3564237"/>
            <a:ext cx="14544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OATL4 (Tax</a:t>
            </a:r>
            <a:r>
              <a:rPr lang="en-US" altLang="ja-JP" sz="1600" b="1" baseline="30000" dirty="0">
                <a:latin typeface="Helvetica" pitchFamily="2" charset="0"/>
              </a:rPr>
              <a:t>+</a:t>
            </a:r>
            <a:r>
              <a:rPr lang="en-US" altLang="ja-JP" sz="1600" b="1" dirty="0">
                <a:latin typeface="Helvetica" pitchFamily="2" charset="0"/>
              </a:rPr>
              <a:t>)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327076" y="523058"/>
            <a:ext cx="16639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TL-Om1 (Tax</a:t>
            </a:r>
            <a:r>
              <a:rPr lang="en-US" altLang="ja-JP" sz="1600" b="1" baseline="30000" dirty="0">
                <a:latin typeface="Helvetica" pitchFamily="2" charset="0"/>
              </a:rPr>
              <a:t>-</a:t>
            </a:r>
            <a:r>
              <a:rPr lang="en-US" altLang="ja-JP" sz="1600" b="1" dirty="0">
                <a:latin typeface="Helvetica" pitchFamily="2" charset="0"/>
              </a:rPr>
              <a:t>)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953253" y="523058"/>
            <a:ext cx="1800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ED40515</a:t>
            </a:r>
            <a:r>
              <a:rPr lang="en-US" altLang="ja-JP" sz="1600" b="1" dirty="0">
                <a:latin typeface="Helvetica" pitchFamily="2" charset="0"/>
              </a:rPr>
              <a:t> (Tax</a:t>
            </a:r>
            <a:r>
              <a:rPr lang="en-US" altLang="ja-JP" sz="1600" b="1" baseline="30000" dirty="0">
                <a:latin typeface="Helvetica" pitchFamily="2" charset="0"/>
              </a:rPr>
              <a:t>-</a:t>
            </a:r>
            <a:r>
              <a:rPr lang="en-US" altLang="ja-JP" sz="1600" b="1" dirty="0">
                <a:latin typeface="Helvetica" pitchFamily="2" charset="0"/>
              </a:rPr>
              <a:t>)</a:t>
            </a:r>
            <a:endParaRPr kumimoji="1" lang="ja-JP" altLang="en-US" sz="1600" b="1">
              <a:latin typeface="Helvetica" pitchFamily="2" charset="0"/>
            </a:endParaRPr>
          </a:p>
        </p:txBody>
      </p:sp>
      <p:pic>
        <p:nvPicPr>
          <p:cNvPr id="17" name="図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5270" y="3861328"/>
            <a:ext cx="2699326" cy="25200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0549" y="861612"/>
            <a:ext cx="2724839" cy="252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45270" y="859352"/>
            <a:ext cx="2724839" cy="252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10549" y="3859974"/>
            <a:ext cx="2724839" cy="25200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13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/>
        </p:nvGraphicFramePr>
        <p:xfrm>
          <a:off x="487624" y="4923112"/>
          <a:ext cx="9258301" cy="10261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7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1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7102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OATL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 h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MS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028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/Tubul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RB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6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1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61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8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6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9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5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6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3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6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#DIV/0!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1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0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6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3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0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8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RF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8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2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83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0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2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9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My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7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6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0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6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2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1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9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5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0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4" name="表 3"/>
          <p:cNvGraphicFramePr>
            <a:graphicFrameLocks noGrp="1"/>
          </p:cNvGraphicFramePr>
          <p:nvPr/>
        </p:nvGraphicFramePr>
        <p:xfrm>
          <a:off x="487624" y="3554960"/>
          <a:ext cx="9258301" cy="10261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7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1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7102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uT10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 h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MS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028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/Tubul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RB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4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6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6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3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9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0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1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6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KZF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0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8.4</a:t>
                      </a: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3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1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4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8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5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7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2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7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6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6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RF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8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2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5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5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5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4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6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5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0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My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6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5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3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1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0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6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4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8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2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4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5" name="表 4"/>
          <p:cNvGraphicFramePr>
            <a:graphicFrameLocks noGrp="1"/>
          </p:cNvGraphicFramePr>
          <p:nvPr/>
        </p:nvGraphicFramePr>
        <p:xfrm>
          <a:off x="487624" y="766696"/>
          <a:ext cx="9258301" cy="10261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7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1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7102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TL-Om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 h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MS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028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/Tubul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RB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2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9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3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7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8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6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7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8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7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70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1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6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7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6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5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1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1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5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7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4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9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8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6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RF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1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4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5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1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5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5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9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3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9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1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7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7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My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9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5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9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8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9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4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6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2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1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6" name="表 5"/>
          <p:cNvGraphicFramePr>
            <a:graphicFrameLocks noGrp="1"/>
          </p:cNvGraphicFramePr>
          <p:nvPr/>
        </p:nvGraphicFramePr>
        <p:xfrm>
          <a:off x="487624" y="2206856"/>
          <a:ext cx="9258301" cy="10261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7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1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7102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ED4051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 h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MS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028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/Tubul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RB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6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5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8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1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7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2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3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88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9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4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1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4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6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7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9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6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7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8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RF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4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7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1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1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2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0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5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7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6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My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3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68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7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7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0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9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5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9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4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7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2" name="表 1"/>
          <p:cNvGraphicFramePr>
            <a:graphicFrameLocks noGrp="1"/>
          </p:cNvGraphicFramePr>
          <p:nvPr/>
        </p:nvGraphicFramePr>
        <p:xfrm>
          <a:off x="487624" y="4923112"/>
          <a:ext cx="9258301" cy="10261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7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1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60472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</a:tblGrid>
              <a:tr h="17102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OATL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 h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DMS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EN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OM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0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0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BE 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028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/Tubulin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RB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6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1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61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8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6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9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5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6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3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6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KZF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11.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5.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4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2.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85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8.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6.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6.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9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6.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.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KZF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1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0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6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5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3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0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8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RF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98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2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83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0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4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32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7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29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3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5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028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My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17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6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20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6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100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2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85.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1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9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95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72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000" u="none" strike="noStrike" dirty="0">
                          <a:effectLst/>
                        </a:rPr>
                        <a:t>60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MS PGothic" panose="020B0600070205080204" pitchFamily="34" charset="-128"/>
                      </a:endParaRPr>
                    </a:p>
                  </a:txBody>
                  <a:tcPr marL="8551" marR="8551" marT="855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0" name="Rectangle 17"/>
          <p:cNvSpPr>
            <a:spLocks noChangeArrowheads="1"/>
          </p:cNvSpPr>
          <p:nvPr/>
        </p:nvSpPr>
        <p:spPr bwMode="auto">
          <a:xfrm>
            <a:off x="576064" y="117297"/>
            <a:ext cx="9319964" cy="398780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e 1</a:t>
            </a:r>
            <a:r>
              <a:rPr lang="en-US" altLang="ja-JP" sz="2000" b="1" dirty="0">
                <a:solidFill>
                  <a:srgbClr val="008F00"/>
                </a:solidFill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7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. Quantitative values of WB signals displayed in Fig. 8A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〜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D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/>
          <p:nvPr/>
        </p:nvGraphicFramePr>
        <p:xfrm>
          <a:off x="974372" y="1494719"/>
          <a:ext cx="8338256" cy="3868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14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14" name="Rectangle 17"/>
          <p:cNvSpPr>
            <a:spLocks noChangeArrowheads="1"/>
          </p:cNvSpPr>
          <p:nvPr/>
        </p:nvSpPr>
        <p:spPr bwMode="auto">
          <a:xfrm>
            <a:off x="288032" y="261313"/>
            <a:ext cx="9319964" cy="398780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e 18. </a:t>
            </a:r>
            <a:r>
              <a:rPr lang="en-US" altLang="ja-JP" sz="2000" b="1" i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HBZ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 mRNA</a:t>
            </a:r>
            <a:r>
              <a:rPr lang="en-US" altLang="ja-JP" sz="2000" b="1" i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 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in TL-Om1 with 12 hour treatment of IMiDs 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  <p:graphicFrame>
        <p:nvGraphicFramePr>
          <p:cNvPr id="12" name="表 11"/>
          <p:cNvGraphicFramePr>
            <a:graphicFrameLocks noGrp="1"/>
          </p:cNvGraphicFramePr>
          <p:nvPr/>
        </p:nvGraphicFramePr>
        <p:xfrm>
          <a:off x="6223620" y="5533491"/>
          <a:ext cx="3024336" cy="406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243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marL="0" marR="0" lvl="0" indent="0" algn="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00" u="none" strike="noStrike" dirty="0">
                          <a:effectLst/>
                          <a:latin typeface="Helvetica" pitchFamily="2" charset="0"/>
                        </a:rPr>
                        <a:t>* POM vs LEN @1</a:t>
                      </a:r>
                      <a:r>
                        <a:rPr lang="el-GR" sz="1000" u="none" strike="noStrike" dirty="0">
                          <a:effectLst/>
                          <a:latin typeface="Helvetica" pitchFamily="2" charset="0"/>
                        </a:rPr>
                        <a:t>μ</a:t>
                      </a:r>
                      <a:r>
                        <a:rPr lang="en-US" sz="1000" u="none" strike="noStrike" dirty="0">
                          <a:effectLst/>
                          <a:latin typeface="Helvetica" pitchFamily="2" charset="0"/>
                        </a:rPr>
                        <a:t>M: </a:t>
                      </a:r>
                      <a:r>
                        <a:rPr lang="en-US" altLang="ja-JP" sz="1000" u="none" strike="noStrike" dirty="0">
                          <a:effectLst/>
                          <a:latin typeface="Helvetica" pitchFamily="2" charset="0"/>
                        </a:rPr>
                        <a:t>P=0.0117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Yu Gothic" panose="020B0400000000000000" pitchFamily="34" charset="-128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u="none" strike="noStrike" dirty="0">
                          <a:effectLst/>
                          <a:latin typeface="Helvetica" pitchFamily="2" charset="0"/>
                        </a:rPr>
                        <a:t>$ IBE vs LEN @10</a:t>
                      </a:r>
                      <a:r>
                        <a:rPr lang="el-GR" sz="1000" u="none" strike="noStrike" dirty="0">
                          <a:effectLst/>
                          <a:latin typeface="Helvetica" pitchFamily="2" charset="0"/>
                        </a:rPr>
                        <a:t>μ</a:t>
                      </a:r>
                      <a:r>
                        <a:rPr lang="en-US" sz="1000" u="none" strike="noStrike" dirty="0">
                          <a:effectLst/>
                          <a:latin typeface="Helvetica" pitchFamily="2" charset="0"/>
                        </a:rPr>
                        <a:t>M: </a:t>
                      </a:r>
                      <a:r>
                        <a:rPr lang="en-US" altLang="ja-JP" sz="1000" u="none" strike="noStrike" dirty="0">
                          <a:effectLst/>
                          <a:latin typeface="Helvetica" pitchFamily="2" charset="0"/>
                        </a:rPr>
                        <a:t>P=0.0112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Yu Gothic" panose="020B0400000000000000" pitchFamily="34" charset="-128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6" name="テキスト ボックス 15"/>
          <p:cNvSpPr txBox="1"/>
          <p:nvPr/>
        </p:nvSpPr>
        <p:spPr>
          <a:xfrm>
            <a:off x="6552000" y="220486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*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992000" y="206084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$</a:t>
            </a:r>
            <a:endParaRPr kumimoji="1" lang="ja-JP" altLang="en-US" sz="120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7"/>
          <p:cNvSpPr>
            <a:spLocks noChangeArrowheads="1"/>
          </p:cNvSpPr>
          <p:nvPr/>
        </p:nvSpPr>
        <p:spPr bwMode="auto">
          <a:xfrm>
            <a:off x="246956" y="116632"/>
            <a:ext cx="9319964" cy="398780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e 19. IBE-mediated targets down-regulation is dependent on CRBN 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964" y="620688"/>
            <a:ext cx="4291301" cy="4797152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245433" y="620688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Helvetica" pitchFamily="2" charset="0"/>
              </a:rPr>
              <a:t>A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927476" y="620688"/>
            <a:ext cx="351378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latin typeface="Helvetica" pitchFamily="2" charset="0"/>
              </a:rPr>
              <a:t>B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8964" y="5531837"/>
            <a:ext cx="97930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IBE-mediated down-regulation of CRBN targets in HuT102 and HuT102-CRBN-KD cells. A.</a:t>
            </a:r>
            <a:r>
              <a:rPr kumimoji="1" lang="en-US" altLang="ja-JP" sz="1200" dirty="0">
                <a:latin typeface="Helvetica" pitchFamily="2" charset="0"/>
              </a:rPr>
              <a:t> Cellular lysates of HuT102 (right panel) </a:t>
            </a:r>
          </a:p>
          <a:p>
            <a:r>
              <a:rPr kumimoji="1" lang="en-US" altLang="ja-JP" sz="1200" dirty="0">
                <a:latin typeface="Helvetica" pitchFamily="2" charset="0"/>
              </a:rPr>
              <a:t>and its CRBN-KD variants (left panel) treated with titrated (0.01, 0.1, 1, 10µM) IBE were resolved and probed with antibodies to CRBN, </a:t>
            </a:r>
          </a:p>
          <a:p>
            <a:r>
              <a:rPr kumimoji="1" lang="en-US" altLang="ja-JP" sz="1200" dirty="0">
                <a:latin typeface="Helvetica" pitchFamily="2" charset="0"/>
              </a:rPr>
              <a:t>IKZF1/3, CK1</a:t>
            </a:r>
            <a:r>
              <a:rPr kumimoji="1" lang="el-GR" altLang="ja-JP" sz="1200" dirty="0">
                <a:latin typeface="Helvetica" pitchFamily="2" charset="0"/>
              </a:rPr>
              <a:t>α, </a:t>
            </a:r>
            <a:r>
              <a:rPr kumimoji="1" lang="en-US" altLang="ja-JP" sz="1200" dirty="0">
                <a:latin typeface="Helvetica" pitchFamily="2" charset="0"/>
              </a:rPr>
              <a:t>IRF4, c-Myc. Tubulin was probed as an internal control. </a:t>
            </a:r>
            <a:r>
              <a:rPr kumimoji="1" lang="en-US" altLang="ja-JP" sz="1200" b="1" dirty="0">
                <a:latin typeface="Helvetica" pitchFamily="2" charset="0"/>
              </a:rPr>
              <a:t>B.</a:t>
            </a:r>
            <a:r>
              <a:rPr kumimoji="1" lang="en-US" altLang="ja-JP" sz="1200" dirty="0">
                <a:latin typeface="Helvetica" pitchFamily="2" charset="0"/>
              </a:rPr>
              <a:t> Relative quantitative values of each signal. Signals with IBE </a:t>
            </a:r>
          </a:p>
          <a:p>
            <a:r>
              <a:rPr kumimoji="1" lang="en-US" altLang="ja-JP" sz="1200" dirty="0">
                <a:latin typeface="Helvetica" pitchFamily="2" charset="0"/>
              </a:rPr>
              <a:t>treatment were divided with DMSO controls. *Relative expression levels of CRBN-KD were between 18.7 and 25.4 % compared to those </a:t>
            </a:r>
          </a:p>
          <a:p>
            <a:r>
              <a:rPr kumimoji="1" lang="en-US" altLang="ja-JP" sz="1200" dirty="0">
                <a:latin typeface="Helvetica" pitchFamily="2" charset="0"/>
              </a:rPr>
              <a:t>of parental HuT102 (right bottom). </a:t>
            </a:r>
            <a:r>
              <a:rPr kumimoji="1" lang="en-US" altLang="ja-JP" sz="1200" b="1" dirty="0">
                <a:latin typeface="Helvetica" pitchFamily="2" charset="0"/>
              </a:rPr>
              <a:t>C.</a:t>
            </a:r>
            <a:r>
              <a:rPr kumimoji="1" lang="en-US" altLang="ja-JP" sz="1200" dirty="0">
                <a:latin typeface="Helvetica" pitchFamily="2" charset="0"/>
              </a:rPr>
              <a:t> HuT102 (Control: blue line) and its CRBN-knock down variants (CRBN-KD: orange line) were treated with indicated concentrations of IBE (0, 0.01, 0.10, 1 and 10µM) for 5 days and their relative viability was compared with </a:t>
            </a:r>
            <a:r>
              <a:rPr kumimoji="1" lang="en-US" altLang="ja-JP" sz="1200" dirty="0" err="1">
                <a:latin typeface="Helvetica" pitchFamily="2" charset="0"/>
              </a:rPr>
              <a:t>CellTiter</a:t>
            </a:r>
            <a:r>
              <a:rPr kumimoji="1" lang="en-US" altLang="ja-JP" sz="1200" dirty="0">
                <a:latin typeface="Helvetica" pitchFamily="2" charset="0"/>
              </a:rPr>
              <a:t> values.</a:t>
            </a: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3796" y="1084481"/>
            <a:ext cx="5544616" cy="1152915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65473A0-53AF-1556-A8F4-FCC867A24E73}"/>
              </a:ext>
            </a:extLst>
          </p:cNvPr>
          <p:cNvSpPr txBox="1"/>
          <p:nvPr/>
        </p:nvSpPr>
        <p:spPr>
          <a:xfrm>
            <a:off x="4927476" y="2412628"/>
            <a:ext cx="351378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FCD84E43-89D4-A555-A250-BFD4099B5C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78854" y="2461022"/>
            <a:ext cx="4750296" cy="3014331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F14F6E-A0EB-2C42-67FD-B11FA21943EC}"/>
              </a:ext>
            </a:extLst>
          </p:cNvPr>
          <p:cNvSpPr txBox="1"/>
          <p:nvPr/>
        </p:nvSpPr>
        <p:spPr>
          <a:xfrm>
            <a:off x="9368574" y="5013176"/>
            <a:ext cx="38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charset="0"/>
              </a:rPr>
              <a:t>**</a:t>
            </a:r>
            <a:endParaRPr kumimoji="1" lang="ja-JP" altLang="en-US" sz="1200">
              <a:latin typeface="Helvetica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93E5F64-2B11-7E7C-7383-3FA4AF87B182}"/>
              </a:ext>
            </a:extLst>
          </p:cNvPr>
          <p:cNvSpPr txBox="1"/>
          <p:nvPr/>
        </p:nvSpPr>
        <p:spPr>
          <a:xfrm>
            <a:off x="8003303" y="3734768"/>
            <a:ext cx="38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charset="0"/>
              </a:rPr>
              <a:t>**</a:t>
            </a:r>
            <a:endParaRPr kumimoji="1" lang="ja-JP" altLang="en-US" sz="1200">
              <a:latin typeface="Helvetica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A6C3F4B-2A2C-FED2-212E-56BC7F9905A4}"/>
              </a:ext>
            </a:extLst>
          </p:cNvPr>
          <p:cNvSpPr txBox="1"/>
          <p:nvPr/>
        </p:nvSpPr>
        <p:spPr>
          <a:xfrm>
            <a:off x="7334714" y="3602055"/>
            <a:ext cx="38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charset="0"/>
              </a:rPr>
              <a:t>**</a:t>
            </a:r>
            <a:endParaRPr kumimoji="1" lang="ja-JP" altLang="en-US" sz="1200">
              <a:latin typeface="Helvetica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90BD0F5-A8AF-CC91-B5A7-FDCFB0DC31D9}"/>
              </a:ext>
            </a:extLst>
          </p:cNvPr>
          <p:cNvSpPr txBox="1"/>
          <p:nvPr/>
        </p:nvSpPr>
        <p:spPr>
          <a:xfrm>
            <a:off x="9448465" y="5133425"/>
            <a:ext cx="5148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P&lt;0.01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F3B91D4-C648-0615-DE51-B12087BE7283}"/>
              </a:ext>
            </a:extLst>
          </p:cNvPr>
          <p:cNvSpPr txBox="1"/>
          <p:nvPr/>
        </p:nvSpPr>
        <p:spPr>
          <a:xfrm>
            <a:off x="8632788" y="3906400"/>
            <a:ext cx="38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charset="0"/>
              </a:rPr>
              <a:t>**</a:t>
            </a:r>
            <a:endParaRPr kumimoji="1" lang="ja-JP" altLang="en-US" sz="1200">
              <a:latin typeface="Helvetica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2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14" name="Rectangle 17"/>
          <p:cNvSpPr>
            <a:spLocks noChangeArrowheads="1"/>
          </p:cNvSpPr>
          <p:nvPr/>
        </p:nvSpPr>
        <p:spPr bwMode="auto">
          <a:xfrm>
            <a:off x="288032" y="260648"/>
            <a:ext cx="9319964" cy="400110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e 2. </a:t>
            </a:r>
            <a:r>
              <a:rPr lang="en-US" altLang="ja-JP" sz="2000" b="1" i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Reagents for western blot and TaqMan-RT-PCR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802" y="859241"/>
            <a:ext cx="6879041" cy="234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7775" y="3435622"/>
            <a:ext cx="8884163" cy="27000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7"/>
          <p:cNvSpPr>
            <a:spLocks noChangeArrowheads="1"/>
          </p:cNvSpPr>
          <p:nvPr/>
        </p:nvSpPr>
        <p:spPr bwMode="auto">
          <a:xfrm>
            <a:off x="0" y="108494"/>
            <a:ext cx="10286999" cy="336246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2000" b="1" dirty="0">
                <a:latin typeface="Helvetica" pitchFamily="2" charset="0"/>
              </a:rPr>
              <a:t>Suppl.3A Relative growth activities of various cell lines treated with lenalidomide</a:t>
            </a:r>
            <a:endParaRPr lang="ja-JP" altLang="en-US" sz="2000" b="1">
              <a:latin typeface="Helvetica" pitchFamily="2" charset="0"/>
            </a:endParaRPr>
          </a:p>
        </p:txBody>
      </p:sp>
      <p:sp>
        <p:nvSpPr>
          <p:cNvPr id="20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3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431532" y="6108794"/>
            <a:ext cx="27109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p</a:t>
            </a:r>
            <a:r>
              <a:rPr kumimoji="1" lang="en-US" altLang="ja-JP" sz="1200" dirty="0">
                <a:latin typeface="Helvetica" pitchFamily="2" charset="0"/>
              </a:rPr>
              <a:t>&lt;0.05: yellow background</a:t>
            </a:r>
          </a:p>
          <a:p>
            <a:r>
              <a:rPr kumimoji="1" lang="en-US" altLang="ja-JP" sz="1200" dirty="0">
                <a:latin typeface="Helvetica" pitchFamily="2" charset="0"/>
              </a:rPr>
              <a:t>p&lt;0.01: yellow background plus bold.</a:t>
            </a:r>
            <a:endParaRPr kumimoji="1" lang="ja-JP" altLang="en-US" sz="1200">
              <a:latin typeface="Helvetica" pitchFamily="2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7076" y="406494"/>
            <a:ext cx="7404100" cy="57023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7"/>
          <p:cNvSpPr>
            <a:spLocks noChangeArrowheads="1"/>
          </p:cNvSpPr>
          <p:nvPr/>
        </p:nvSpPr>
        <p:spPr bwMode="auto">
          <a:xfrm>
            <a:off x="246956" y="796639"/>
            <a:ext cx="4063380" cy="336246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2000" b="1" dirty="0">
                <a:latin typeface="Helvetica" pitchFamily="2" charset="0"/>
              </a:rPr>
              <a:t>Suppl.3B Standard deviations</a:t>
            </a:r>
            <a:endParaRPr lang="ja-JP" altLang="en-US" sz="2000" b="1">
              <a:latin typeface="Helvetica" pitchFamily="2" charset="0"/>
            </a:endParaRPr>
          </a:p>
        </p:txBody>
      </p:sp>
      <p:sp>
        <p:nvSpPr>
          <p:cNvPr id="20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4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956" y="1484784"/>
            <a:ext cx="4686664" cy="3600000"/>
          </a:xfrm>
          <a:prstGeom prst="rect">
            <a:avLst/>
          </a:prstGeom>
        </p:spPr>
      </p:pic>
      <p:sp>
        <p:nvSpPr>
          <p:cNvPr id="3" name="Rectangle 17"/>
          <p:cNvSpPr>
            <a:spLocks noChangeArrowheads="1"/>
          </p:cNvSpPr>
          <p:nvPr/>
        </p:nvSpPr>
        <p:spPr bwMode="auto">
          <a:xfrm>
            <a:off x="5173217" y="826281"/>
            <a:ext cx="4434780" cy="336246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2000" b="1" dirty="0">
                <a:latin typeface="Helvetica" pitchFamily="2" charset="0"/>
              </a:rPr>
              <a:t>Suppl.3C. p-values</a:t>
            </a:r>
            <a:endParaRPr lang="ja-JP" altLang="en-US" sz="2000" b="1">
              <a:latin typeface="Helvetica" pitchFamily="2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79776" y="1484784"/>
            <a:ext cx="4670219" cy="359679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5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10" name="Rectangle 17"/>
          <p:cNvSpPr>
            <a:spLocks noChangeArrowheads="1"/>
          </p:cNvSpPr>
          <p:nvPr/>
        </p:nvSpPr>
        <p:spPr bwMode="auto">
          <a:xfrm>
            <a:off x="174948" y="116632"/>
            <a:ext cx="9937104" cy="707886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. 4. Gene numbers significantly affected by LEN-treatment in HuT102 and OATL4  </a:t>
            </a:r>
            <a:endParaRPr lang="ja-JP" altLang="en-US" sz="2000" b="1">
              <a:effectLst>
                <a:outerShdw blurRad="38100" dist="12700" dir="2700000" algn="tl" rotWithShape="0">
                  <a:prstClr val="black">
                    <a:alpha val="40000"/>
                  </a:prstClr>
                </a:outerShdw>
              </a:effectLst>
              <a:latin typeface="Helvetica"/>
              <a:ea typeface="ヒラギノ丸ゴ Pro W4"/>
              <a:cs typeface="Helvetica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3100" y="1539442"/>
            <a:ext cx="6552778" cy="3779115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図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5056" y="1089000"/>
            <a:ext cx="5769310" cy="2340000"/>
          </a:xfrm>
          <a:prstGeom prst="rect">
            <a:avLst/>
          </a:prstGeom>
        </p:spPr>
      </p:pic>
      <p:sp>
        <p:nvSpPr>
          <p:cNvPr id="13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6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823020" y="764704"/>
            <a:ext cx="26642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HuT102 (LEN-sensitive)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23020" y="3736654"/>
            <a:ext cx="2808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OATL4 (LEN-resistant)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20" name="Rectangle 17"/>
          <p:cNvSpPr>
            <a:spLocks noChangeArrowheads="1"/>
          </p:cNvSpPr>
          <p:nvPr/>
        </p:nvSpPr>
        <p:spPr bwMode="auto">
          <a:xfrm>
            <a:off x="0" y="44624"/>
            <a:ext cx="10287000" cy="707886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t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.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 5. </a:t>
            </a: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</a:rPr>
              <a:t>Distinct LEN-induced gene expression profiles between HuT102 and OATL4 </a:t>
            </a:r>
            <a:endParaRPr lang="zh-CN" altLang="en-US" sz="2000" dirty="0">
              <a:solidFill>
                <a:schemeClr val="tx2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38940" y="692696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008F00"/>
                </a:solidFill>
                <a:latin typeface="Helvetica" pitchFamily="2" charset="0"/>
              </a:rPr>
              <a:t>A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43650" y="3635732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008F00"/>
                </a:solidFill>
                <a:latin typeface="Helvetica" pitchFamily="2" charset="0"/>
              </a:rPr>
              <a:t>B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3780000" y="1535886"/>
            <a:ext cx="432000" cy="1728000"/>
          </a:xfrm>
          <a:prstGeom prst="rect">
            <a:avLst/>
          </a:prstGeom>
          <a:solidFill>
            <a:schemeClr val="bg1">
              <a:alpha val="21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793625" y="3228268"/>
            <a:ext cx="3946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itchFamily="2" charset="0"/>
              </a:rPr>
              <a:t>FDA</a:t>
            </a:r>
            <a:endParaRPr kumimoji="1" lang="ja-JP" altLang="en-US" sz="800" b="1">
              <a:latin typeface="Helvetica" pitchFamily="2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2000" y="4073266"/>
            <a:ext cx="5769310" cy="2340000"/>
          </a:xfrm>
          <a:prstGeom prst="rect">
            <a:avLst/>
          </a:prstGeom>
        </p:spPr>
      </p:pic>
      <p:sp>
        <p:nvSpPr>
          <p:cNvPr id="24" name="正方形/長方形 23"/>
          <p:cNvSpPr/>
          <p:nvPr/>
        </p:nvSpPr>
        <p:spPr>
          <a:xfrm>
            <a:off x="3780000" y="4458114"/>
            <a:ext cx="432000" cy="1728000"/>
          </a:xfrm>
          <a:prstGeom prst="rect">
            <a:avLst/>
          </a:prstGeom>
          <a:solidFill>
            <a:schemeClr val="bg1">
              <a:alpha val="21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793625" y="6150496"/>
            <a:ext cx="3946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itchFamily="2" charset="0"/>
              </a:rPr>
              <a:t>FDA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979856" y="5951601"/>
            <a:ext cx="10502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itchFamily="2" charset="0"/>
              </a:rPr>
              <a:t>** FDR&lt;0.05</a:t>
            </a:r>
          </a:p>
          <a:p>
            <a:pPr algn="r"/>
            <a:r>
              <a:rPr lang="en-US" altLang="ja-JP" sz="1200" b="1" dirty="0">
                <a:latin typeface="Helvetica" pitchFamily="2" charset="0"/>
              </a:rPr>
              <a:t> *FDR&lt;0.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799684" y="44460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972128" y="1535886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483431" y="17084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454748" y="1880914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829904" y="2053428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453211" y="48348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855468" y="50292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7131887" y="46404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274719" y="52236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174330" y="54180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298257" y="56124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867382" y="580680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255582" y="6001200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587156" y="2225942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367636" y="2398456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718993" y="2570970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494822" y="2743484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215508" y="2916000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*</a:t>
            </a:r>
            <a:endParaRPr kumimoji="1" lang="ja-JP" altLang="en-US" sz="800" b="1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スライド番号プレースホルダ 5"/>
          <p:cNvSpPr>
            <a:spLocks noGrp="1"/>
          </p:cNvSpPr>
          <p:nvPr>
            <p:ph type="sldNum" sz="quarter" idx="12"/>
          </p:nvPr>
        </p:nvSpPr>
        <p:spPr>
          <a:xfrm>
            <a:off x="9607996" y="6650434"/>
            <a:ext cx="683999" cy="234950"/>
          </a:xfrm>
          <a:noFill/>
        </p:spPr>
        <p:txBody>
          <a:bodyPr anchor="ctr"/>
          <a:lstStyle>
            <a:lvl1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1pPr>
            <a:lvl2pPr marL="37931725" indent="-37474525"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2pPr>
            <a:lvl3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3pPr>
            <a:lvl4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4pPr>
            <a:lvl5pPr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Helvetica" pitchFamily="2" charset="0"/>
                <a:ea typeface="ヒラギノ角ゴ Pro W6" charset="0"/>
                <a:cs typeface="ヒラギノ角ゴ Pro W6" charset="0"/>
              </a:defRPr>
            </a:lvl9pPr>
          </a:lstStyle>
          <a:p>
            <a:fld id="{3E355984-8FB0-0644-BF93-71B48E5C848D}" type="slidenum">
              <a:rPr lang="en-US" altLang="ja-JP" b="0">
                <a:latin typeface="Helvetica"/>
                <a:ea typeface="MS PGothic" panose="020B0600070205080204" pitchFamily="34" charset="-128"/>
                <a:cs typeface="Helvetica"/>
              </a:rPr>
              <a:t>7</a:t>
            </a:fld>
            <a:endParaRPr lang="en-US" altLang="ja-JP" b="0" dirty="0">
              <a:latin typeface="Helvetica"/>
              <a:ea typeface="MS PGothic" panose="020B0600070205080204" pitchFamily="34" charset="-128"/>
              <a:cs typeface="Helvetica"/>
            </a:endParaRPr>
          </a:p>
        </p:txBody>
      </p:sp>
      <p:sp>
        <p:nvSpPr>
          <p:cNvPr id="20" name="Rectangle 17"/>
          <p:cNvSpPr>
            <a:spLocks noChangeArrowheads="1"/>
          </p:cNvSpPr>
          <p:nvPr/>
        </p:nvSpPr>
        <p:spPr bwMode="auto">
          <a:xfrm>
            <a:off x="0" y="44624"/>
            <a:ext cx="10287000" cy="70675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t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  <a:sym typeface="+mn-ea"/>
              </a:rPr>
              <a:t>Suppl.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  <a:sym typeface="+mn-ea"/>
              </a:rPr>
              <a:t> 5. </a:t>
            </a: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  <a:sym typeface="+mn-ea"/>
              </a:rPr>
              <a:t>Distinct LEN-induced gene expression profiles between HuT102 and OATL4 </a:t>
            </a:r>
            <a:endParaRPr lang="zh-CN" altLang="en-US" sz="2000">
              <a:solidFill>
                <a:schemeClr val="tx2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45433" y="1164377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008F00"/>
                </a:solidFill>
                <a:latin typeface="Helvetica" pitchFamily="2" charset="0"/>
              </a:rPr>
              <a:t>C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132588" y="1164377"/>
            <a:ext cx="351378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rgbClr val="008F00"/>
                </a:solidFill>
                <a:latin typeface="Helvetica" pitchFamily="2" charset="0"/>
              </a:rPr>
              <a:t>D</a:t>
            </a:r>
          </a:p>
        </p:txBody>
      </p:sp>
      <p:grpSp>
        <p:nvGrpSpPr>
          <p:cNvPr id="41" name="グループ化 40"/>
          <p:cNvGrpSpPr/>
          <p:nvPr/>
        </p:nvGrpSpPr>
        <p:grpSpPr>
          <a:xfrm>
            <a:off x="8989496" y="2191742"/>
            <a:ext cx="546492" cy="830997"/>
            <a:chOff x="4068000" y="5184000"/>
            <a:chExt cx="546492" cy="830997"/>
          </a:xfrm>
        </p:grpSpPr>
        <p:sp>
          <p:nvSpPr>
            <p:cNvPr id="25" name="正方形/長方形 24"/>
            <p:cNvSpPr/>
            <p:nvPr/>
          </p:nvSpPr>
          <p:spPr>
            <a:xfrm>
              <a:off x="4068000" y="5184000"/>
              <a:ext cx="504056" cy="8309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円/楕円 7"/>
            <p:cNvSpPr/>
            <p:nvPr/>
          </p:nvSpPr>
          <p:spPr>
            <a:xfrm>
              <a:off x="4172716" y="5257317"/>
              <a:ext cx="72008" cy="72008"/>
            </a:xfrm>
            <a:prstGeom prst="ellipse">
              <a:avLst/>
            </a:prstGeom>
            <a:solidFill>
              <a:srgbClr val="FFFFD4"/>
            </a:solidFill>
            <a:ln w="6350">
              <a:solidFill>
                <a:srgbClr val="0B6596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円/楕円 11"/>
            <p:cNvSpPr/>
            <p:nvPr/>
          </p:nvSpPr>
          <p:spPr>
            <a:xfrm>
              <a:off x="4172716" y="5379454"/>
              <a:ext cx="72008" cy="72008"/>
            </a:xfrm>
            <a:prstGeom prst="ellipse">
              <a:avLst/>
            </a:prstGeom>
            <a:solidFill>
              <a:srgbClr val="FFE392"/>
            </a:solidFill>
            <a:ln w="6350">
              <a:solidFill>
                <a:srgbClr val="0B6596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円/楕円 13"/>
            <p:cNvSpPr/>
            <p:nvPr/>
          </p:nvSpPr>
          <p:spPr>
            <a:xfrm>
              <a:off x="4172716" y="5623728"/>
              <a:ext cx="72008" cy="72008"/>
            </a:xfrm>
            <a:prstGeom prst="ellipse">
              <a:avLst/>
            </a:prstGeom>
            <a:solidFill>
              <a:srgbClr val="FE9928"/>
            </a:solidFill>
            <a:ln w="6350">
              <a:solidFill>
                <a:srgbClr val="0B6596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円/楕円 14"/>
            <p:cNvSpPr/>
            <p:nvPr/>
          </p:nvSpPr>
          <p:spPr>
            <a:xfrm>
              <a:off x="4172716" y="5745865"/>
              <a:ext cx="72008" cy="72008"/>
            </a:xfrm>
            <a:prstGeom prst="ellipse">
              <a:avLst/>
            </a:prstGeom>
            <a:solidFill>
              <a:srgbClr val="D95F0D"/>
            </a:solidFill>
            <a:ln w="6350">
              <a:solidFill>
                <a:srgbClr val="0B6596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円/楕円 17"/>
            <p:cNvSpPr/>
            <p:nvPr/>
          </p:nvSpPr>
          <p:spPr>
            <a:xfrm>
              <a:off x="4172716" y="5868000"/>
              <a:ext cx="72008" cy="72008"/>
            </a:xfrm>
            <a:prstGeom prst="ellipse">
              <a:avLst/>
            </a:prstGeom>
            <a:solidFill>
              <a:srgbClr val="983404"/>
            </a:solidFill>
            <a:ln w="6350">
              <a:solidFill>
                <a:srgbClr val="0B6596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円/楕円 21"/>
            <p:cNvSpPr/>
            <p:nvPr/>
          </p:nvSpPr>
          <p:spPr>
            <a:xfrm>
              <a:off x="4172716" y="5501591"/>
              <a:ext cx="72008" cy="72008"/>
            </a:xfrm>
            <a:prstGeom prst="ellipse">
              <a:avLst/>
            </a:prstGeom>
            <a:solidFill>
              <a:srgbClr val="FEC44F"/>
            </a:solidFill>
            <a:ln w="6350">
              <a:solidFill>
                <a:srgbClr val="0B6596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4215024" y="5184000"/>
              <a:ext cx="399468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</a:t>
              </a:r>
              <a:r>
                <a:rPr kumimoji="1" lang="en-US" altLang="ja-JP" sz="800" baseline="30000" dirty="0">
                  <a:latin typeface="Helvetica" pitchFamily="2" charset="0"/>
                </a:rPr>
                <a:t>-2</a:t>
              </a:r>
            </a:p>
            <a:p>
              <a:r>
                <a:rPr lang="en-US" altLang="ja-JP" sz="800" dirty="0">
                  <a:latin typeface="Helvetica" pitchFamily="2" charset="0"/>
                </a:rPr>
                <a:t>10</a:t>
              </a:r>
              <a:r>
                <a:rPr lang="en-US" altLang="ja-JP" sz="800" baseline="30000" dirty="0">
                  <a:latin typeface="Helvetica" pitchFamily="2" charset="0"/>
                </a:rPr>
                <a:t>-3</a:t>
              </a:r>
            </a:p>
            <a:p>
              <a:r>
                <a:rPr kumimoji="1" lang="en-US" altLang="ja-JP" sz="800" dirty="0">
                  <a:latin typeface="Helvetica" pitchFamily="2" charset="0"/>
                </a:rPr>
                <a:t>10</a:t>
              </a:r>
              <a:r>
                <a:rPr kumimoji="1" lang="en-US" altLang="ja-JP" sz="800" baseline="30000" dirty="0">
                  <a:latin typeface="Helvetica" pitchFamily="2" charset="0"/>
                </a:rPr>
                <a:t>-4</a:t>
              </a:r>
            </a:p>
            <a:p>
              <a:r>
                <a:rPr lang="en-US" altLang="ja-JP" sz="800" dirty="0">
                  <a:latin typeface="Helvetica" pitchFamily="2" charset="0"/>
                </a:rPr>
                <a:t>10</a:t>
              </a:r>
              <a:r>
                <a:rPr lang="en-US" altLang="ja-JP" sz="800" baseline="30000" dirty="0">
                  <a:latin typeface="Helvetica" pitchFamily="2" charset="0"/>
                </a:rPr>
                <a:t>-6</a:t>
              </a:r>
            </a:p>
            <a:p>
              <a:r>
                <a:rPr kumimoji="1" lang="en-US" altLang="ja-JP" sz="800" dirty="0">
                  <a:latin typeface="Helvetica" pitchFamily="2" charset="0"/>
                </a:rPr>
                <a:t>10</a:t>
              </a:r>
              <a:r>
                <a:rPr kumimoji="1" lang="en-US" altLang="ja-JP" sz="800" baseline="30000" dirty="0">
                  <a:latin typeface="Helvetica" pitchFamily="2" charset="0"/>
                </a:rPr>
                <a:t>-10</a:t>
              </a:r>
            </a:p>
            <a:p>
              <a:r>
                <a:rPr lang="en-US" altLang="ja-JP" sz="800" dirty="0">
                  <a:latin typeface="Helvetica" pitchFamily="2" charset="0"/>
                </a:rPr>
                <a:t>10</a:t>
              </a:r>
              <a:r>
                <a:rPr lang="en-US" altLang="ja-JP" sz="800" baseline="30000" dirty="0">
                  <a:latin typeface="Helvetica" pitchFamily="2" charset="0"/>
                </a:rPr>
                <a:t>-20</a:t>
              </a:r>
              <a:endParaRPr kumimoji="1" lang="ja-JP" altLang="en-US" sz="800" baseline="30000">
                <a:latin typeface="Helvetica" pitchFamily="2" charset="0"/>
              </a:endParaRPr>
            </a:p>
          </p:txBody>
        </p:sp>
      </p:grpSp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0827" y="1338437"/>
            <a:ext cx="3240000" cy="2555837"/>
          </a:xfrm>
          <a:prstGeom prst="rect">
            <a:avLst/>
          </a:prstGeom>
        </p:spPr>
      </p:pic>
      <p:sp>
        <p:nvSpPr>
          <p:cNvPr id="70" name="テキスト ボックス 69"/>
          <p:cNvSpPr txBox="1"/>
          <p:nvPr/>
        </p:nvSpPr>
        <p:spPr>
          <a:xfrm>
            <a:off x="740827" y="3385523"/>
            <a:ext cx="344677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Kinase              Lipid response       Cytokine response           Cancer          Cell death          Small mol transport</a:t>
            </a:r>
            <a:endParaRPr kumimoji="1" lang="ja-JP" altLang="en-US" sz="500" b="1">
              <a:latin typeface="Helvetica" pitchFamily="2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61457" y="3644587"/>
            <a:ext cx="1080120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                    Protein </a:t>
            </a:r>
          </a:p>
          <a:p>
            <a:pPr>
              <a:lnSpc>
                <a:spcPts val="600"/>
              </a:lnSpc>
            </a:pPr>
            <a:r>
              <a:rPr lang="en-US" altLang="ja-JP" sz="500" b="1" dirty="0">
                <a:latin typeface="Helvetica" pitchFamily="2" charset="0"/>
              </a:rPr>
              <a:t>                  </a:t>
            </a:r>
            <a:r>
              <a:rPr kumimoji="1" lang="en-US" altLang="ja-JP" sz="500" b="1" dirty="0">
                <a:latin typeface="Helvetica" pitchFamily="2" charset="0"/>
              </a:rPr>
              <a:t>       folding</a:t>
            </a:r>
          </a:p>
          <a:p>
            <a:pPr>
              <a:lnSpc>
                <a:spcPts val="200"/>
              </a:lnSpc>
            </a:pPr>
            <a:endParaRPr lang="en-US" altLang="ja-JP" sz="200" b="1" dirty="0">
              <a:latin typeface="Helvetica" pitchFamily="2" charset="0"/>
            </a:endParaRPr>
          </a:p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Protein</a:t>
            </a:r>
            <a:endParaRPr lang="en-US" altLang="ja-JP" sz="500" b="1" dirty="0">
              <a:latin typeface="Helvetica" pitchFamily="2" charset="0"/>
            </a:endParaRPr>
          </a:p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     localization</a:t>
            </a:r>
            <a:endParaRPr kumimoji="1" lang="ja-JP" altLang="en-US" sz="500" b="1">
              <a:latin typeface="Helvetica" pitchFamily="2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245524" y="1532471"/>
            <a:ext cx="1008609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Innate </a:t>
            </a:r>
          </a:p>
          <a:p>
            <a:r>
              <a:rPr kumimoji="1" lang="en-US" altLang="ja-JP" sz="500" b="1" dirty="0">
                <a:latin typeface="Helvetica" pitchFamily="2" charset="0"/>
              </a:rPr>
              <a:t>immunity       </a:t>
            </a:r>
          </a:p>
          <a:p>
            <a:endParaRPr lang="en-US" altLang="ja-JP" sz="500" b="1" dirty="0">
              <a:latin typeface="Helvetica" pitchFamily="2" charset="0"/>
            </a:endParaRPr>
          </a:p>
          <a:p>
            <a:endParaRPr kumimoji="1" lang="en-US" altLang="ja-JP" sz="500" b="1" dirty="0">
              <a:latin typeface="Helvetica" pitchFamily="2" charset="0"/>
            </a:endParaRPr>
          </a:p>
          <a:p>
            <a:endParaRPr lang="en-US" altLang="ja-JP" sz="500" b="1" dirty="0">
              <a:latin typeface="Helvetica" pitchFamily="2" charset="0"/>
            </a:endParaRPr>
          </a:p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                       Cytokine</a:t>
            </a:r>
          </a:p>
          <a:p>
            <a:pPr>
              <a:lnSpc>
                <a:spcPts val="600"/>
              </a:lnSpc>
            </a:pPr>
            <a:r>
              <a:rPr lang="en-US" altLang="ja-JP" sz="500" b="1" dirty="0">
                <a:latin typeface="Helvetica" pitchFamily="2" charset="0"/>
              </a:rPr>
              <a:t>                            production</a:t>
            </a:r>
            <a:endParaRPr kumimoji="1" lang="en-US" altLang="ja-JP" sz="500" b="1" dirty="0">
              <a:latin typeface="Helvetica" pitchFamily="2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1109529" y="2633226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Chromosome</a:t>
            </a:r>
          </a:p>
          <a:p>
            <a:pPr>
              <a:lnSpc>
                <a:spcPts val="600"/>
              </a:lnSpc>
            </a:pPr>
            <a:r>
              <a:rPr lang="en-US" altLang="ja-JP" sz="500" b="1" dirty="0">
                <a:latin typeface="Helvetica" pitchFamily="2" charset="0"/>
              </a:rPr>
              <a:t>    organization</a:t>
            </a:r>
            <a:endParaRPr kumimoji="1" lang="en-US" altLang="ja-JP" sz="500" b="1" dirty="0">
              <a:latin typeface="Helvetica" pitchFamily="2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2517657" y="1707708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RNA </a:t>
            </a:r>
          </a:p>
          <a:p>
            <a:r>
              <a:rPr kumimoji="1" lang="en-US" altLang="ja-JP" sz="500" b="1" dirty="0">
                <a:latin typeface="Helvetica" pitchFamily="2" charset="0"/>
              </a:rPr>
              <a:t>metabolism</a:t>
            </a: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105369" y="2215904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ncRNA </a:t>
            </a:r>
          </a:p>
          <a:p>
            <a:r>
              <a:rPr kumimoji="1" lang="en-US" altLang="ja-JP" sz="500" b="1" dirty="0">
                <a:latin typeface="Helvetica" pitchFamily="2" charset="0"/>
              </a:rPr>
              <a:t>metabolism</a:t>
            </a: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1591978" y="1796780"/>
            <a:ext cx="4780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Cell cycle</a:t>
            </a: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724201" y="1707707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G1/S </a:t>
            </a:r>
          </a:p>
          <a:p>
            <a:r>
              <a:rPr lang="en-US" altLang="ja-JP" sz="500" b="1" dirty="0">
                <a:latin typeface="Helvetica" pitchFamily="2" charset="0"/>
              </a:rPr>
              <a:t>mitosis</a:t>
            </a:r>
            <a:endParaRPr kumimoji="1" lang="en-US" altLang="ja-JP" sz="500" b="1" dirty="0">
              <a:latin typeface="Helvetica" pitchFamily="2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596811" y="2442242"/>
            <a:ext cx="4267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PID/E2F</a:t>
            </a: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431191" y="1250443"/>
            <a:ext cx="4619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CCT/TriC</a:t>
            </a: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659071" y="1406182"/>
            <a:ext cx="54213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Hemostasis</a:t>
            </a: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2979484" y="2365925"/>
            <a:ext cx="72968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Immune response</a:t>
            </a: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83377" y="1301629"/>
            <a:ext cx="3240000" cy="2555837"/>
          </a:xfrm>
          <a:prstGeom prst="rect">
            <a:avLst/>
          </a:prstGeom>
        </p:spPr>
      </p:pic>
      <p:pic>
        <p:nvPicPr>
          <p:cNvPr id="30" name="図 2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0986" y="3644587"/>
            <a:ext cx="2313093" cy="2347009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5508621" y="3356673"/>
            <a:ext cx="344677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Kinase              Lipid response       Cytokine response           Cancer          Cell death          Small mol transport</a:t>
            </a:r>
            <a:endParaRPr kumimoji="1" lang="ja-JP" altLang="en-US" sz="500" b="1">
              <a:latin typeface="Helvetica" pitchFamily="2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229251" y="3615737"/>
            <a:ext cx="1080120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                    Protein </a:t>
            </a:r>
          </a:p>
          <a:p>
            <a:pPr>
              <a:lnSpc>
                <a:spcPts val="600"/>
              </a:lnSpc>
            </a:pPr>
            <a:r>
              <a:rPr lang="en-US" altLang="ja-JP" sz="500" b="1" dirty="0">
                <a:latin typeface="Helvetica" pitchFamily="2" charset="0"/>
              </a:rPr>
              <a:t>                  </a:t>
            </a:r>
            <a:r>
              <a:rPr kumimoji="1" lang="en-US" altLang="ja-JP" sz="500" b="1" dirty="0">
                <a:latin typeface="Helvetica" pitchFamily="2" charset="0"/>
              </a:rPr>
              <a:t>       folding</a:t>
            </a:r>
          </a:p>
          <a:p>
            <a:pPr>
              <a:lnSpc>
                <a:spcPts val="200"/>
              </a:lnSpc>
            </a:pPr>
            <a:endParaRPr lang="en-US" altLang="ja-JP" sz="200" b="1" dirty="0">
              <a:latin typeface="Helvetica" pitchFamily="2" charset="0"/>
            </a:endParaRPr>
          </a:p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Protein</a:t>
            </a:r>
            <a:endParaRPr lang="en-US" altLang="ja-JP" sz="500" b="1" dirty="0">
              <a:latin typeface="Helvetica" pitchFamily="2" charset="0"/>
            </a:endParaRPr>
          </a:p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     localization</a:t>
            </a:r>
            <a:endParaRPr kumimoji="1" lang="ja-JP" altLang="en-US" sz="500" b="1">
              <a:latin typeface="Helvetica" pitchFamily="2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7981568" y="1294071"/>
            <a:ext cx="1008609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Innate </a:t>
            </a:r>
          </a:p>
          <a:p>
            <a:r>
              <a:rPr kumimoji="1" lang="en-US" altLang="ja-JP" sz="500" b="1" dirty="0">
                <a:latin typeface="Helvetica" pitchFamily="2" charset="0"/>
              </a:rPr>
              <a:t>immunity       </a:t>
            </a:r>
          </a:p>
          <a:p>
            <a:endParaRPr lang="en-US" altLang="ja-JP" sz="500" b="1" dirty="0">
              <a:latin typeface="Helvetica" pitchFamily="2" charset="0"/>
            </a:endParaRPr>
          </a:p>
          <a:p>
            <a:endParaRPr kumimoji="1" lang="en-US" altLang="ja-JP" sz="500" b="1" dirty="0">
              <a:latin typeface="Helvetica" pitchFamily="2" charset="0"/>
            </a:endParaRPr>
          </a:p>
          <a:p>
            <a:endParaRPr lang="en-US" altLang="ja-JP" sz="500" b="1" dirty="0">
              <a:latin typeface="Helvetica" pitchFamily="2" charset="0"/>
            </a:endParaRPr>
          </a:p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                       Cytokine</a:t>
            </a:r>
          </a:p>
          <a:p>
            <a:pPr>
              <a:lnSpc>
                <a:spcPts val="600"/>
              </a:lnSpc>
            </a:pPr>
            <a:r>
              <a:rPr lang="en-US" altLang="ja-JP" sz="500" b="1" dirty="0">
                <a:latin typeface="Helvetica" pitchFamily="2" charset="0"/>
              </a:rPr>
              <a:t>                            production</a:t>
            </a:r>
            <a:endParaRPr kumimoji="1" lang="en-US" altLang="ja-JP" sz="500" b="1" dirty="0">
              <a:latin typeface="Helvetica" pitchFamily="2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877323" y="2604376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kumimoji="1" lang="en-US" altLang="ja-JP" sz="500" b="1" dirty="0">
                <a:latin typeface="Helvetica" pitchFamily="2" charset="0"/>
              </a:rPr>
              <a:t>Chromosome</a:t>
            </a:r>
          </a:p>
          <a:p>
            <a:pPr>
              <a:lnSpc>
                <a:spcPts val="600"/>
              </a:lnSpc>
            </a:pPr>
            <a:r>
              <a:rPr lang="en-US" altLang="ja-JP" sz="500" b="1" dirty="0">
                <a:latin typeface="Helvetica" pitchFamily="2" charset="0"/>
              </a:rPr>
              <a:t>    organization</a:t>
            </a:r>
            <a:endParaRPr kumimoji="1" lang="en-US" altLang="ja-JP" sz="500" b="1" dirty="0">
              <a:latin typeface="Helvetica" pitchFamily="2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7285451" y="1678858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RNA </a:t>
            </a:r>
          </a:p>
          <a:p>
            <a:r>
              <a:rPr kumimoji="1" lang="en-US" altLang="ja-JP" sz="500" b="1" dirty="0">
                <a:latin typeface="Helvetica" pitchFamily="2" charset="0"/>
              </a:rPr>
              <a:t>metabolism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873163" y="2187054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ncRNA </a:t>
            </a:r>
          </a:p>
          <a:p>
            <a:r>
              <a:rPr kumimoji="1" lang="en-US" altLang="ja-JP" sz="500" b="1" dirty="0">
                <a:latin typeface="Helvetica" pitchFamily="2" charset="0"/>
              </a:rPr>
              <a:t>metabolism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6359772" y="1767930"/>
            <a:ext cx="4780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Cell cycle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491995" y="1678857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G1/S </a:t>
            </a:r>
          </a:p>
          <a:p>
            <a:r>
              <a:rPr lang="en-US" altLang="ja-JP" sz="500" b="1" dirty="0">
                <a:latin typeface="Helvetica" pitchFamily="2" charset="0"/>
              </a:rPr>
              <a:t>mitosis</a:t>
            </a:r>
            <a:endParaRPr kumimoji="1" lang="en-US" altLang="ja-JP" sz="500" b="1" dirty="0">
              <a:latin typeface="Helvetica" pitchFamily="2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364605" y="2413392"/>
            <a:ext cx="4267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PID/E2F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198985" y="1221593"/>
            <a:ext cx="4619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CCT/TriC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426865" y="1377332"/>
            <a:ext cx="54213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Hemostasis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7747278" y="2337075"/>
            <a:ext cx="72968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Helvetica" pitchFamily="2" charset="0"/>
              </a:rPr>
              <a:t>Immune response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7"/>
          <p:cNvSpPr>
            <a:spLocks noChangeArrowheads="1"/>
          </p:cNvSpPr>
          <p:nvPr/>
        </p:nvSpPr>
        <p:spPr bwMode="auto">
          <a:xfrm>
            <a:off x="0" y="44624"/>
            <a:ext cx="10287000" cy="70675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t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.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 6. </a:t>
            </a: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</a:rPr>
              <a:t>The overlapping differentially expressed genes (DEGs) between HuT102 and OATL4 under effect of LEN</a:t>
            </a:r>
            <a:endParaRPr lang="zh-CN" altLang="en-US" sz="2000" dirty="0">
              <a:solidFill>
                <a:schemeClr val="tx2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18595" y="1628686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Helvetica" pitchFamily="2" charset="0"/>
              </a:rPr>
              <a:t>A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503635" y="1700252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Helvetica" pitchFamily="2" charset="0"/>
              </a:rPr>
              <a:t>B</a:t>
            </a: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1038860" y="2276475"/>
            <a:ext cx="3892550" cy="32258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6"/>
          <a:stretch>
            <a:fillRect/>
          </a:stretch>
        </p:blipFill>
        <p:spPr>
          <a:xfrm rot="10800000">
            <a:off x="6079490" y="2276475"/>
            <a:ext cx="3693160" cy="315341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967105" y="1484630"/>
            <a:ext cx="7753350" cy="1676400"/>
          </a:xfrm>
          <a:prstGeom prst="rect">
            <a:avLst/>
          </a:prstGeom>
        </p:spPr>
      </p:pic>
      <p:sp>
        <p:nvSpPr>
          <p:cNvPr id="20" name="Rectangle 17"/>
          <p:cNvSpPr>
            <a:spLocks noChangeArrowheads="1"/>
          </p:cNvSpPr>
          <p:nvPr>
            <p:custDataLst>
              <p:tags r:id="rId2"/>
            </p:custDataLst>
          </p:nvPr>
        </p:nvSpPr>
        <p:spPr bwMode="auto">
          <a:xfrm>
            <a:off x="0" y="44624"/>
            <a:ext cx="10287000" cy="109156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anchor="t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/>
                <a:ea typeface="ヒラギノ丸ゴ Pro W4"/>
                <a:cs typeface="Helvetica"/>
              </a:rPr>
              <a:t>Suppl.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 1</a:t>
            </a:r>
            <a:r>
              <a:rPr lang="en-US" altLang="ja-JP" sz="2000" b="1" dirty="0">
                <a:solidFill>
                  <a:srgbClr val="008F00"/>
                </a:solidFill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4</a:t>
            </a:r>
            <a:r>
              <a:rPr lang="en-US" altLang="ja-JP" sz="2000" b="1" dirty="0">
                <a:effectLst>
                  <a:outerShdw blurRad="38100" dist="12700" dir="2700000" algn="tl" rotWithShape="0">
                    <a:prstClr val="black">
                      <a:alpha val="40000"/>
                    </a:prstClr>
                  </a:outerShdw>
                </a:effectLst>
                <a:latin typeface="Helvetica" pitchFamily="2" charset="0"/>
                <a:ea typeface="ヒラギノ丸ゴ Pro W4"/>
                <a:cs typeface="Helvetica"/>
              </a:rPr>
              <a:t>. </a:t>
            </a: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</a:rPr>
              <a:t>LEN-induced gene expression profiles of ED40515, and the comparison of ED40515 with HuT102 and OATL4</a:t>
            </a:r>
          </a:p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ja-JP" sz="2000" b="1" dirty="0">
                <a:solidFill>
                  <a:schemeClr val="tx2">
                    <a:lumMod val="50000"/>
                  </a:schemeClr>
                </a:solidFill>
                <a:latin typeface="Helvetica" pitchFamily="2" charset="0"/>
                <a:ea typeface="ヒラギノ丸ゴ Pro W4"/>
                <a:cs typeface="Arial" panose="020B0604020202020204" pitchFamily="34" charset="0"/>
              </a:rPr>
              <a:t> </a:t>
            </a:r>
            <a:endParaRPr lang="zh-CN" altLang="en-US" sz="2000" dirty="0">
              <a:solidFill>
                <a:schemeClr val="tx2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16" name="テキスト ボックス 15"/>
          <p:cNvSpPr txBox="1"/>
          <p:nvPr>
            <p:custDataLst>
              <p:tags r:id="rId3"/>
            </p:custDataLst>
          </p:nvPr>
        </p:nvSpPr>
        <p:spPr>
          <a:xfrm>
            <a:off x="390848" y="1052617"/>
            <a:ext cx="45599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Helvetica" pitchFamily="2" charset="0"/>
              </a:rPr>
              <a:t>A. ED40515(LEN-resistant, Tax negative)</a:t>
            </a:r>
          </a:p>
        </p:txBody>
      </p:sp>
      <p:pic>
        <p:nvPicPr>
          <p:cNvPr id="7" name="图片 6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5863590" y="3644900"/>
            <a:ext cx="3291840" cy="261175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5935345" y="6236970"/>
            <a:ext cx="742315" cy="21336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8362950" y="3500755"/>
            <a:ext cx="998220" cy="109855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9175750" y="5516880"/>
            <a:ext cx="589915" cy="113093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751205" y="3644900"/>
            <a:ext cx="2822575" cy="231013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3199130" y="3573145"/>
            <a:ext cx="1005840" cy="103060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895350" y="6236970"/>
            <a:ext cx="609600" cy="17843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2983230" y="5949315"/>
            <a:ext cx="2383790" cy="68770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DVjMzEyM2M5NGFmYTAwNmMyNmZiMDZlZDRiMzYwMzc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592</Words>
  <Application>Microsoft Macintosh PowerPoint</Application>
  <PresentationFormat>35mm スライド</PresentationFormat>
  <Paragraphs>609</Paragraphs>
  <Slides>15</Slides>
  <Notes>1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5</vt:i4>
      </vt:variant>
    </vt:vector>
  </HeadingPairs>
  <TitlesOfParts>
    <vt:vector size="19" baseType="lpstr">
      <vt:lpstr>ヒラギノ角ゴ Pro W3</vt:lpstr>
      <vt:lpstr>Arial</vt:lpstr>
      <vt:lpstr>Helvetica</vt:lpstr>
      <vt:lpstr>標準デザイ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大分大学医学部感染分子病態制御講座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波 英克</dc:creator>
  <cp:lastModifiedBy>Iha Hidekatsu</cp:lastModifiedBy>
  <cp:revision>3350</cp:revision>
  <cp:lastPrinted>2022-10-17T00:36:00Z</cp:lastPrinted>
  <dcterms:created xsi:type="dcterms:W3CDTF">2010-06-29T04:26:00Z</dcterms:created>
  <dcterms:modified xsi:type="dcterms:W3CDTF">2023-11-06T04:56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7675DA309E44D03A460470E985519F9_13</vt:lpwstr>
  </property>
  <property fmtid="{D5CDD505-2E9C-101B-9397-08002B2CF9AE}" pid="3" name="KSOProductBuildVer">
    <vt:lpwstr>2052-12.1.0.15712</vt:lpwstr>
  </property>
</Properties>
</file>